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4"/>
  </p:sldMasterIdLst>
  <p:sldIdLst>
    <p:sldId id="259" r:id="rId5"/>
    <p:sldId id="263" r:id="rId6"/>
    <p:sldId id="260" r:id="rId7"/>
    <p:sldId id="261" r:id="rId8"/>
    <p:sldId id="262" r:id="rId9"/>
  </p:sldIdLst>
  <p:sldSz cx="6480175" cy="88201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A629DC8-64EE-4B7D-90B0-C0B554E1FD54}" v="34" dt="2020-11-26T11:21:05.53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7" d="100"/>
          <a:sy n="87" d="100"/>
        </p:scale>
        <p:origin x="233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5" Type="http://schemas.microsoft.com/office/2015/10/relationships/revisionInfo" Target="revisionInfo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illiam" userId="abd8c3f5-ff38-4d7d-ae66-861c24974fed" providerId="ADAL" clId="{8D1387C2-2C73-467F-A60B-C2058C600CD1}"/>
    <pc:docChg chg="undo custSel addSld delSld modSld">
      <pc:chgData name="William" userId="abd8c3f5-ff38-4d7d-ae66-861c24974fed" providerId="ADAL" clId="{8D1387C2-2C73-467F-A60B-C2058C600CD1}" dt="2020-06-02T08:32:31.603" v="467" actId="20577"/>
      <pc:docMkLst>
        <pc:docMk/>
      </pc:docMkLst>
      <pc:sldChg chg="del">
        <pc:chgData name="William" userId="abd8c3f5-ff38-4d7d-ae66-861c24974fed" providerId="ADAL" clId="{8D1387C2-2C73-467F-A60B-C2058C600CD1}" dt="2020-06-01T09:27:24.629" v="4" actId="47"/>
        <pc:sldMkLst>
          <pc:docMk/>
          <pc:sldMk cId="604586935" sldId="256"/>
        </pc:sldMkLst>
      </pc:sldChg>
      <pc:sldChg chg="del">
        <pc:chgData name="William" userId="abd8c3f5-ff38-4d7d-ae66-861c24974fed" providerId="ADAL" clId="{8D1387C2-2C73-467F-A60B-C2058C600CD1}" dt="2020-06-01T09:27:21.279" v="2" actId="47"/>
        <pc:sldMkLst>
          <pc:docMk/>
          <pc:sldMk cId="1071791954" sldId="257"/>
        </pc:sldMkLst>
      </pc:sldChg>
      <pc:sldChg chg="del">
        <pc:chgData name="William" userId="abd8c3f5-ff38-4d7d-ae66-861c24974fed" providerId="ADAL" clId="{8D1387C2-2C73-467F-A60B-C2058C600CD1}" dt="2020-06-01T09:27:23.074" v="3" actId="47"/>
        <pc:sldMkLst>
          <pc:docMk/>
          <pc:sldMk cId="3994895703" sldId="258"/>
        </pc:sldMkLst>
      </pc:sldChg>
      <pc:sldChg chg="addSp delSp modSp add del mod">
        <pc:chgData name="William" userId="abd8c3f5-ff38-4d7d-ae66-861c24974fed" providerId="ADAL" clId="{8D1387C2-2C73-467F-A60B-C2058C600CD1}" dt="2020-06-01T09:31:01.776" v="89" actId="1076"/>
        <pc:sldMkLst>
          <pc:docMk/>
          <pc:sldMk cId="4019928299" sldId="259"/>
        </pc:sldMkLst>
        <pc:spChg chg="add del mod">
          <ac:chgData name="William" userId="abd8c3f5-ff38-4d7d-ae66-861c24974fed" providerId="ADAL" clId="{8D1387C2-2C73-467F-A60B-C2058C600CD1}" dt="2020-06-01T09:28:16.005" v="8" actId="478"/>
          <ac:spMkLst>
            <pc:docMk/>
            <pc:sldMk cId="4019928299" sldId="259"/>
            <ac:spMk id="2" creationId="{046A5721-4565-44CB-8117-FFCF35DE206E}"/>
          </ac:spMkLst>
        </pc:spChg>
        <pc:spChg chg="add del mod">
          <ac:chgData name="William" userId="abd8c3f5-ff38-4d7d-ae66-861c24974fed" providerId="ADAL" clId="{8D1387C2-2C73-467F-A60B-C2058C600CD1}" dt="2020-06-01T09:30:31.149" v="61" actId="478"/>
          <ac:spMkLst>
            <pc:docMk/>
            <pc:sldMk cId="4019928299" sldId="259"/>
            <ac:spMk id="12" creationId="{0CB621AB-516A-4841-B611-8429111E0E82}"/>
          </ac:spMkLst>
        </pc:spChg>
        <pc:spChg chg="add mod">
          <ac:chgData name="William" userId="abd8c3f5-ff38-4d7d-ae66-861c24974fed" providerId="ADAL" clId="{8D1387C2-2C73-467F-A60B-C2058C600CD1}" dt="2020-06-01T09:31:01.776" v="89" actId="1076"/>
          <ac:spMkLst>
            <pc:docMk/>
            <pc:sldMk cId="4019928299" sldId="259"/>
            <ac:spMk id="13" creationId="{2E47872E-59B4-41AA-B723-06747DABEF79}"/>
          </ac:spMkLst>
        </pc:spChg>
        <pc:picChg chg="add del mod">
          <ac:chgData name="William" userId="abd8c3f5-ff38-4d7d-ae66-861c24974fed" providerId="ADAL" clId="{8D1387C2-2C73-467F-A60B-C2058C600CD1}" dt="2020-06-01T09:29:33.168" v="33" actId="1036"/>
          <ac:picMkLst>
            <pc:docMk/>
            <pc:sldMk cId="4019928299" sldId="259"/>
            <ac:picMk id="3" creationId="{576278B3-9697-4846-8E71-B78EEF4F1252}"/>
          </ac:picMkLst>
        </pc:picChg>
        <pc:picChg chg="add del mod">
          <ac:chgData name="William" userId="abd8c3f5-ff38-4d7d-ae66-861c24974fed" providerId="ADAL" clId="{8D1387C2-2C73-467F-A60B-C2058C600CD1}" dt="2020-06-01T09:29:19.395" v="21" actId="1036"/>
          <ac:picMkLst>
            <pc:docMk/>
            <pc:sldMk cId="4019928299" sldId="259"/>
            <ac:picMk id="4" creationId="{9F2C756A-DEA9-41F2-8DDF-9296E4C03F57}"/>
          </ac:picMkLst>
        </pc:picChg>
        <pc:picChg chg="add del mod">
          <ac:chgData name="William" userId="abd8c3f5-ff38-4d7d-ae66-861c24974fed" providerId="ADAL" clId="{8D1387C2-2C73-467F-A60B-C2058C600CD1}" dt="2020-06-01T09:29:33.168" v="33" actId="1036"/>
          <ac:picMkLst>
            <pc:docMk/>
            <pc:sldMk cId="4019928299" sldId="259"/>
            <ac:picMk id="5" creationId="{AB21A5C9-76BA-4184-BB2C-FD572C6FD57F}"/>
          </ac:picMkLst>
        </pc:picChg>
        <pc:picChg chg="add del mod">
          <ac:chgData name="William" userId="abd8c3f5-ff38-4d7d-ae66-861c24974fed" providerId="ADAL" clId="{8D1387C2-2C73-467F-A60B-C2058C600CD1}" dt="2020-06-01T09:29:48.545" v="45" actId="1035"/>
          <ac:picMkLst>
            <pc:docMk/>
            <pc:sldMk cId="4019928299" sldId="259"/>
            <ac:picMk id="6" creationId="{A7CE5908-7434-4F88-9D9F-2717D94473BD}"/>
          </ac:picMkLst>
        </pc:picChg>
        <pc:picChg chg="add del mod">
          <ac:chgData name="William" userId="abd8c3f5-ff38-4d7d-ae66-861c24974fed" providerId="ADAL" clId="{8D1387C2-2C73-467F-A60B-C2058C600CD1}" dt="2020-06-01T09:29:48.545" v="45" actId="1035"/>
          <ac:picMkLst>
            <pc:docMk/>
            <pc:sldMk cId="4019928299" sldId="259"/>
            <ac:picMk id="7" creationId="{4C77A1F8-CA46-46A6-B47B-3ED9591FFC34}"/>
          </ac:picMkLst>
        </pc:picChg>
        <pc:picChg chg="add del mod">
          <ac:chgData name="William" userId="abd8c3f5-ff38-4d7d-ae66-861c24974fed" providerId="ADAL" clId="{8D1387C2-2C73-467F-A60B-C2058C600CD1}" dt="2020-06-01T09:29:59.929" v="57" actId="1035"/>
          <ac:picMkLst>
            <pc:docMk/>
            <pc:sldMk cId="4019928299" sldId="259"/>
            <ac:picMk id="8" creationId="{70DC06D7-1203-4642-BA9F-52A93E36FA20}"/>
          </ac:picMkLst>
        </pc:picChg>
        <pc:picChg chg="add del mod">
          <ac:chgData name="William" userId="abd8c3f5-ff38-4d7d-ae66-861c24974fed" providerId="ADAL" clId="{8D1387C2-2C73-467F-A60B-C2058C600CD1}" dt="2020-06-01T09:29:59.929" v="57" actId="1035"/>
          <ac:picMkLst>
            <pc:docMk/>
            <pc:sldMk cId="4019928299" sldId="259"/>
            <ac:picMk id="9" creationId="{3CD4929C-E5D1-4ABA-96A9-EBE6CC2E4B62}"/>
          </ac:picMkLst>
        </pc:picChg>
        <pc:picChg chg="add del mod">
          <ac:chgData name="William" userId="abd8c3f5-ff38-4d7d-ae66-861c24974fed" providerId="ADAL" clId="{8D1387C2-2C73-467F-A60B-C2058C600CD1}" dt="2020-06-01T09:30:41.078" v="62" actId="1076"/>
          <ac:picMkLst>
            <pc:docMk/>
            <pc:sldMk cId="4019928299" sldId="259"/>
            <ac:picMk id="10" creationId="{BF51EF53-9F2B-429B-A656-17E2CDE05A35}"/>
          </ac:picMkLst>
        </pc:picChg>
        <pc:picChg chg="add del mod">
          <ac:chgData name="William" userId="abd8c3f5-ff38-4d7d-ae66-861c24974fed" providerId="ADAL" clId="{8D1387C2-2C73-467F-A60B-C2058C600CD1}" dt="2020-06-01T09:29:19.395" v="21" actId="1036"/>
          <ac:picMkLst>
            <pc:docMk/>
            <pc:sldMk cId="4019928299" sldId="259"/>
            <ac:picMk id="11" creationId="{1ECC7DBF-D8D4-4947-98A7-E9DA1BB4BAD3}"/>
          </ac:picMkLst>
        </pc:picChg>
      </pc:sldChg>
      <pc:sldChg chg="addSp delSp modSp new mod">
        <pc:chgData name="William" userId="abd8c3f5-ff38-4d7d-ae66-861c24974fed" providerId="ADAL" clId="{8D1387C2-2C73-467F-A60B-C2058C600CD1}" dt="2020-06-02T08:32:18.436" v="462" actId="1076"/>
        <pc:sldMkLst>
          <pc:docMk/>
          <pc:sldMk cId="1853063641" sldId="260"/>
        </pc:sldMkLst>
        <pc:spChg chg="del">
          <ac:chgData name="William" userId="abd8c3f5-ff38-4d7d-ae66-861c24974fed" providerId="ADAL" clId="{8D1387C2-2C73-467F-A60B-C2058C600CD1}" dt="2020-06-01T19:15:45.551" v="91" actId="478"/>
          <ac:spMkLst>
            <pc:docMk/>
            <pc:sldMk cId="1853063641" sldId="260"/>
            <ac:spMk id="2" creationId="{FE1159EF-19D0-45C2-A195-848970FAAAFA}"/>
          </ac:spMkLst>
        </pc:spChg>
        <pc:spChg chg="del">
          <ac:chgData name="William" userId="abd8c3f5-ff38-4d7d-ae66-861c24974fed" providerId="ADAL" clId="{8D1387C2-2C73-467F-A60B-C2058C600CD1}" dt="2020-06-01T19:15:48.968" v="92" actId="478"/>
          <ac:spMkLst>
            <pc:docMk/>
            <pc:sldMk cId="1853063641" sldId="260"/>
            <ac:spMk id="3" creationId="{BD3A5CCF-E8DD-429C-B75B-A668D1026FDE}"/>
          </ac:spMkLst>
        </pc:spChg>
        <pc:spChg chg="add mod">
          <ac:chgData name="William" userId="abd8c3f5-ff38-4d7d-ae66-861c24974fed" providerId="ADAL" clId="{8D1387C2-2C73-467F-A60B-C2058C600CD1}" dt="2020-06-02T08:29:57.952" v="410" actId="1076"/>
          <ac:spMkLst>
            <pc:docMk/>
            <pc:sldMk cId="1853063641" sldId="260"/>
            <ac:spMk id="9" creationId="{BE9BE345-ADB8-4612-9863-37F18C1603BD}"/>
          </ac:spMkLst>
        </pc:spChg>
        <pc:spChg chg="add mod">
          <ac:chgData name="William" userId="abd8c3f5-ff38-4d7d-ae66-861c24974fed" providerId="ADAL" clId="{8D1387C2-2C73-467F-A60B-C2058C600CD1}" dt="2020-06-02T08:30:15.150" v="418" actId="1076"/>
          <ac:spMkLst>
            <pc:docMk/>
            <pc:sldMk cId="1853063641" sldId="260"/>
            <ac:spMk id="10" creationId="{5BEE1EB1-220B-4272-A1E0-7A6F37B48211}"/>
          </ac:spMkLst>
        </pc:spChg>
        <pc:spChg chg="add mod">
          <ac:chgData name="William" userId="abd8c3f5-ff38-4d7d-ae66-861c24974fed" providerId="ADAL" clId="{8D1387C2-2C73-467F-A60B-C2058C600CD1}" dt="2020-06-02T08:30:04.768" v="416" actId="1035"/>
          <ac:spMkLst>
            <pc:docMk/>
            <pc:sldMk cId="1853063641" sldId="260"/>
            <ac:spMk id="11" creationId="{4253699A-5B64-4E50-B2EE-D308308E377D}"/>
          </ac:spMkLst>
        </pc:spChg>
        <pc:spChg chg="add mod">
          <ac:chgData name="William" userId="abd8c3f5-ff38-4d7d-ae66-861c24974fed" providerId="ADAL" clId="{8D1387C2-2C73-467F-A60B-C2058C600CD1}" dt="2020-06-02T08:30:08.861" v="417" actId="1076"/>
          <ac:spMkLst>
            <pc:docMk/>
            <pc:sldMk cId="1853063641" sldId="260"/>
            <ac:spMk id="12" creationId="{F7F22A0B-4237-4BA9-B487-C552C7CD4ADF}"/>
          </ac:spMkLst>
        </pc:spChg>
        <pc:spChg chg="add mod">
          <ac:chgData name="William" userId="abd8c3f5-ff38-4d7d-ae66-861c24974fed" providerId="ADAL" clId="{8D1387C2-2C73-467F-A60B-C2058C600CD1}" dt="2020-06-02T08:29:51.390" v="409" actId="1076"/>
          <ac:spMkLst>
            <pc:docMk/>
            <pc:sldMk cId="1853063641" sldId="260"/>
            <ac:spMk id="13" creationId="{57E9E167-5D10-429D-9FA3-A01A6F085679}"/>
          </ac:spMkLst>
        </pc:spChg>
        <pc:spChg chg="add mod">
          <ac:chgData name="William" userId="abd8c3f5-ff38-4d7d-ae66-861c24974fed" providerId="ADAL" clId="{8D1387C2-2C73-467F-A60B-C2058C600CD1}" dt="2020-06-02T08:30:41.544" v="433" actId="1076"/>
          <ac:spMkLst>
            <pc:docMk/>
            <pc:sldMk cId="1853063641" sldId="260"/>
            <ac:spMk id="14" creationId="{4B12FBBE-86EE-4707-BC36-FEC7EB14E4CA}"/>
          </ac:spMkLst>
        </pc:spChg>
        <pc:spChg chg="add mod">
          <ac:chgData name="William" userId="abd8c3f5-ff38-4d7d-ae66-861c24974fed" providerId="ADAL" clId="{8D1387C2-2C73-467F-A60B-C2058C600CD1}" dt="2020-06-02T08:30:49.423" v="435" actId="1076"/>
          <ac:spMkLst>
            <pc:docMk/>
            <pc:sldMk cId="1853063641" sldId="260"/>
            <ac:spMk id="15" creationId="{4F5F02C7-19A0-4437-80B2-4486E3FB01E4}"/>
          </ac:spMkLst>
        </pc:spChg>
        <pc:spChg chg="add mod">
          <ac:chgData name="William" userId="abd8c3f5-ff38-4d7d-ae66-861c24974fed" providerId="ADAL" clId="{8D1387C2-2C73-467F-A60B-C2058C600CD1}" dt="2020-06-02T08:30:53.420" v="437" actId="1076"/>
          <ac:spMkLst>
            <pc:docMk/>
            <pc:sldMk cId="1853063641" sldId="260"/>
            <ac:spMk id="16" creationId="{E7AC43AF-40DC-4BBF-8797-8BA0C4D0AA8E}"/>
          </ac:spMkLst>
        </pc:spChg>
        <pc:spChg chg="add mod">
          <ac:chgData name="William" userId="abd8c3f5-ff38-4d7d-ae66-861c24974fed" providerId="ADAL" clId="{8D1387C2-2C73-467F-A60B-C2058C600CD1}" dt="2020-06-02T08:31:02.826" v="443" actId="1038"/>
          <ac:spMkLst>
            <pc:docMk/>
            <pc:sldMk cId="1853063641" sldId="260"/>
            <ac:spMk id="17" creationId="{DE9EA2FD-A561-4018-8EC4-2E79B6D7CB84}"/>
          </ac:spMkLst>
        </pc:spChg>
        <pc:spChg chg="add mod">
          <ac:chgData name="William" userId="abd8c3f5-ff38-4d7d-ae66-861c24974fed" providerId="ADAL" clId="{8D1387C2-2C73-467F-A60B-C2058C600CD1}" dt="2020-06-02T08:31:15.294" v="448" actId="1076"/>
          <ac:spMkLst>
            <pc:docMk/>
            <pc:sldMk cId="1853063641" sldId="260"/>
            <ac:spMk id="18" creationId="{8154B5F7-AC31-443F-B252-61ADA284D504}"/>
          </ac:spMkLst>
        </pc:spChg>
        <pc:spChg chg="add mod">
          <ac:chgData name="William" userId="abd8c3f5-ff38-4d7d-ae66-861c24974fed" providerId="ADAL" clId="{8D1387C2-2C73-467F-A60B-C2058C600CD1}" dt="2020-06-02T08:31:28.532" v="452" actId="20577"/>
          <ac:spMkLst>
            <pc:docMk/>
            <pc:sldMk cId="1853063641" sldId="260"/>
            <ac:spMk id="19" creationId="{1C2CFE72-BA30-4843-8AF6-011ABCCD09C0}"/>
          </ac:spMkLst>
        </pc:spChg>
        <pc:spChg chg="add mod">
          <ac:chgData name="William" userId="abd8c3f5-ff38-4d7d-ae66-861c24974fed" providerId="ADAL" clId="{8D1387C2-2C73-467F-A60B-C2058C600CD1}" dt="2020-06-02T08:31:37.683" v="454" actId="1076"/>
          <ac:spMkLst>
            <pc:docMk/>
            <pc:sldMk cId="1853063641" sldId="260"/>
            <ac:spMk id="20" creationId="{7EAFABA3-63D9-405A-99D3-E33C9DC157AC}"/>
          </ac:spMkLst>
        </pc:spChg>
        <pc:spChg chg="add mod">
          <ac:chgData name="William" userId="abd8c3f5-ff38-4d7d-ae66-861c24974fed" providerId="ADAL" clId="{8D1387C2-2C73-467F-A60B-C2058C600CD1}" dt="2020-06-02T08:31:43.635" v="456" actId="1076"/>
          <ac:spMkLst>
            <pc:docMk/>
            <pc:sldMk cId="1853063641" sldId="260"/>
            <ac:spMk id="21" creationId="{A521B8D7-D7E0-4A82-9D21-8E30B9934828}"/>
          </ac:spMkLst>
        </pc:spChg>
        <pc:spChg chg="add mod">
          <ac:chgData name="William" userId="abd8c3f5-ff38-4d7d-ae66-861c24974fed" providerId="ADAL" clId="{8D1387C2-2C73-467F-A60B-C2058C600CD1}" dt="2020-06-02T08:32:18.436" v="462" actId="1076"/>
          <ac:spMkLst>
            <pc:docMk/>
            <pc:sldMk cId="1853063641" sldId="260"/>
            <ac:spMk id="22" creationId="{B916290D-7D32-4375-89CD-D19CD7F26BCD}"/>
          </ac:spMkLst>
        </pc:spChg>
        <pc:picChg chg="add del mod modCrop">
          <ac:chgData name="William" userId="abd8c3f5-ff38-4d7d-ae66-861c24974fed" providerId="ADAL" clId="{8D1387C2-2C73-467F-A60B-C2058C600CD1}" dt="2020-06-01T19:34:56.288" v="107" actId="478"/>
          <ac:picMkLst>
            <pc:docMk/>
            <pc:sldMk cId="1853063641" sldId="260"/>
            <ac:picMk id="4" creationId="{D236BC08-ACB8-478B-8CF0-34984840152E}"/>
          </ac:picMkLst>
        </pc:picChg>
        <pc:picChg chg="add mod modCrop">
          <ac:chgData name="William" userId="abd8c3f5-ff38-4d7d-ae66-861c24974fed" providerId="ADAL" clId="{8D1387C2-2C73-467F-A60B-C2058C600CD1}" dt="2020-06-02T08:26:33.536" v="311" actId="1076"/>
          <ac:picMkLst>
            <pc:docMk/>
            <pc:sldMk cId="1853063641" sldId="260"/>
            <ac:picMk id="5" creationId="{4D902354-ADF0-48FD-ABA4-98ECB65F7DE9}"/>
          </ac:picMkLst>
        </pc:picChg>
        <pc:picChg chg="add mod modCrop">
          <ac:chgData name="William" userId="abd8c3f5-ff38-4d7d-ae66-861c24974fed" providerId="ADAL" clId="{8D1387C2-2C73-467F-A60B-C2058C600CD1}" dt="2020-06-02T08:26:37.116" v="312" actId="1076"/>
          <ac:picMkLst>
            <pc:docMk/>
            <pc:sldMk cId="1853063641" sldId="260"/>
            <ac:picMk id="6" creationId="{1AD3DFE9-A2BF-49D7-AEEE-32F3C2D29027}"/>
          </ac:picMkLst>
        </pc:picChg>
        <pc:picChg chg="add del mod modCrop">
          <ac:chgData name="William" userId="abd8c3f5-ff38-4d7d-ae66-861c24974fed" providerId="ADAL" clId="{8D1387C2-2C73-467F-A60B-C2058C600CD1}" dt="2020-06-02T08:25:24.881" v="305" actId="478"/>
          <ac:picMkLst>
            <pc:docMk/>
            <pc:sldMk cId="1853063641" sldId="260"/>
            <ac:picMk id="7" creationId="{AA3B2781-694B-4691-BFE2-02608299C74D}"/>
          </ac:picMkLst>
        </pc:picChg>
        <pc:picChg chg="add del mod modCrop">
          <ac:chgData name="William" userId="abd8c3f5-ff38-4d7d-ae66-861c24974fed" providerId="ADAL" clId="{8D1387C2-2C73-467F-A60B-C2058C600CD1}" dt="2020-06-02T08:25:22.774" v="304" actId="478"/>
          <ac:picMkLst>
            <pc:docMk/>
            <pc:sldMk cId="1853063641" sldId="260"/>
            <ac:picMk id="8" creationId="{980B9F5C-1D3B-4FB3-842A-9C595EE170BB}"/>
          </ac:picMkLst>
        </pc:picChg>
      </pc:sldChg>
      <pc:sldChg chg="addSp delSp modSp add mod">
        <pc:chgData name="William" userId="abd8c3f5-ff38-4d7d-ae66-861c24974fed" providerId="ADAL" clId="{8D1387C2-2C73-467F-A60B-C2058C600CD1}" dt="2020-06-02T08:32:31.603" v="467" actId="20577"/>
        <pc:sldMkLst>
          <pc:docMk/>
          <pc:sldMk cId="3108368087" sldId="261"/>
        </pc:sldMkLst>
        <pc:spChg chg="add mod">
          <ac:chgData name="William" userId="abd8c3f5-ff38-4d7d-ae66-861c24974fed" providerId="ADAL" clId="{8D1387C2-2C73-467F-A60B-C2058C600CD1}" dt="2020-06-02T08:24:58.387" v="293" actId="1076"/>
          <ac:spMkLst>
            <pc:docMk/>
            <pc:sldMk cId="3108368087" sldId="261"/>
            <ac:spMk id="4" creationId="{587C8B08-1AE4-4DE0-99AC-917357539E8A}"/>
          </ac:spMkLst>
        </pc:spChg>
        <pc:spChg chg="add mod">
          <ac:chgData name="William" userId="abd8c3f5-ff38-4d7d-ae66-861c24974fed" providerId="ADAL" clId="{8D1387C2-2C73-467F-A60B-C2058C600CD1}" dt="2020-06-02T08:25:06.827" v="299" actId="20577"/>
          <ac:spMkLst>
            <pc:docMk/>
            <pc:sldMk cId="3108368087" sldId="261"/>
            <ac:spMk id="9" creationId="{47CC8703-EAFF-4AD1-BA06-E0C5BB689A31}"/>
          </ac:spMkLst>
        </pc:spChg>
        <pc:spChg chg="add mod">
          <ac:chgData name="William" userId="abd8c3f5-ff38-4d7d-ae66-861c24974fed" providerId="ADAL" clId="{8D1387C2-2C73-467F-A60B-C2058C600CD1}" dt="2020-06-02T08:25:13.966" v="303" actId="20577"/>
          <ac:spMkLst>
            <pc:docMk/>
            <pc:sldMk cId="3108368087" sldId="261"/>
            <ac:spMk id="10" creationId="{9E22969A-F3FD-4189-A09E-18E63452E411}"/>
          </ac:spMkLst>
        </pc:spChg>
        <pc:spChg chg="add mod">
          <ac:chgData name="William" userId="abd8c3f5-ff38-4d7d-ae66-861c24974fed" providerId="ADAL" clId="{8D1387C2-2C73-467F-A60B-C2058C600CD1}" dt="2020-06-02T08:32:31.603" v="467" actId="20577"/>
          <ac:spMkLst>
            <pc:docMk/>
            <pc:sldMk cId="3108368087" sldId="261"/>
            <ac:spMk id="11" creationId="{252F948A-1040-40AF-8667-C72BEA0A1625}"/>
          </ac:spMkLst>
        </pc:spChg>
        <pc:graphicFrameChg chg="add mod modGraphic">
          <ac:chgData name="William" userId="abd8c3f5-ff38-4d7d-ae66-861c24974fed" providerId="ADAL" clId="{8D1387C2-2C73-467F-A60B-C2058C600CD1}" dt="2020-06-02T08:24:44.145" v="285" actId="14100"/>
          <ac:graphicFrameMkLst>
            <pc:docMk/>
            <pc:sldMk cId="3108368087" sldId="261"/>
            <ac:graphicFrameMk id="2" creationId="{0638A2FF-F767-4BAC-861A-6A520DE63844}"/>
          </ac:graphicFrameMkLst>
        </pc:graphicFrameChg>
        <pc:picChg chg="del">
          <ac:chgData name="William" userId="abd8c3f5-ff38-4d7d-ae66-861c24974fed" providerId="ADAL" clId="{8D1387C2-2C73-467F-A60B-C2058C600CD1}" dt="2020-06-02T08:19:31.040" v="159" actId="478"/>
          <ac:picMkLst>
            <pc:docMk/>
            <pc:sldMk cId="3108368087" sldId="261"/>
            <ac:picMk id="5" creationId="{4D902354-ADF0-48FD-ABA4-98ECB65F7DE9}"/>
          </ac:picMkLst>
        </pc:picChg>
        <pc:picChg chg="del">
          <ac:chgData name="William" userId="abd8c3f5-ff38-4d7d-ae66-861c24974fed" providerId="ADAL" clId="{8D1387C2-2C73-467F-A60B-C2058C600CD1}" dt="2020-06-02T08:19:30.442" v="158" actId="478"/>
          <ac:picMkLst>
            <pc:docMk/>
            <pc:sldMk cId="3108368087" sldId="261"/>
            <ac:picMk id="6" creationId="{1AD3DFE9-A2BF-49D7-AEEE-32F3C2D29027}"/>
          </ac:picMkLst>
        </pc:picChg>
        <pc:picChg chg="mod">
          <ac:chgData name="William" userId="abd8c3f5-ff38-4d7d-ae66-861c24974fed" providerId="ADAL" clId="{8D1387C2-2C73-467F-A60B-C2058C600CD1}" dt="2020-06-02T08:24:28.978" v="280" actId="1076"/>
          <ac:picMkLst>
            <pc:docMk/>
            <pc:sldMk cId="3108368087" sldId="261"/>
            <ac:picMk id="7" creationId="{AA3B2781-694B-4691-BFE2-02608299C74D}"/>
          </ac:picMkLst>
        </pc:picChg>
        <pc:picChg chg="mod">
          <ac:chgData name="William" userId="abd8c3f5-ff38-4d7d-ae66-861c24974fed" providerId="ADAL" clId="{8D1387C2-2C73-467F-A60B-C2058C600CD1}" dt="2020-06-02T08:24:31.436" v="281" actId="1076"/>
          <ac:picMkLst>
            <pc:docMk/>
            <pc:sldMk cId="3108368087" sldId="261"/>
            <ac:picMk id="8" creationId="{980B9F5C-1D3B-4FB3-842A-9C595EE170BB}"/>
          </ac:picMkLst>
        </pc:picChg>
      </pc:sldChg>
      <pc:sldChg chg="delSp new del mod">
        <pc:chgData name="William" userId="abd8c3f5-ff38-4d7d-ae66-861c24974fed" providerId="ADAL" clId="{8D1387C2-2C73-467F-A60B-C2058C600CD1}" dt="2020-06-02T08:19:24.667" v="156" actId="47"/>
        <pc:sldMkLst>
          <pc:docMk/>
          <pc:sldMk cId="3870684034" sldId="261"/>
        </pc:sldMkLst>
        <pc:spChg chg="del">
          <ac:chgData name="William" userId="abd8c3f5-ff38-4d7d-ae66-861c24974fed" providerId="ADAL" clId="{8D1387C2-2C73-467F-A60B-C2058C600CD1}" dt="2020-06-02T08:19:20.441" v="154" actId="478"/>
          <ac:spMkLst>
            <pc:docMk/>
            <pc:sldMk cId="3870684034" sldId="261"/>
            <ac:spMk id="2" creationId="{62581394-D702-4537-8E1A-F605ADB6EFD2}"/>
          </ac:spMkLst>
        </pc:spChg>
        <pc:spChg chg="del">
          <ac:chgData name="William" userId="abd8c3f5-ff38-4d7d-ae66-861c24974fed" providerId="ADAL" clId="{8D1387C2-2C73-467F-A60B-C2058C600CD1}" dt="2020-06-02T08:19:21.231" v="155" actId="478"/>
          <ac:spMkLst>
            <pc:docMk/>
            <pc:sldMk cId="3870684034" sldId="261"/>
            <ac:spMk id="3" creationId="{E37D4C6F-57D6-4F7F-BD85-AED8762C9D9B}"/>
          </ac:spMkLst>
        </pc:spChg>
      </pc:sldChg>
    </pc:docChg>
  </pc:docChgLst>
  <pc:docChgLst>
    <pc:chgData name="William" userId="abd8c3f5-ff38-4d7d-ae66-861c24974fed" providerId="ADAL" clId="{BFA09A3D-6871-4CCE-ADFE-55371EFCD2BF}"/>
    <pc:docChg chg="modSld">
      <pc:chgData name="William" userId="abd8c3f5-ff38-4d7d-ae66-861c24974fed" providerId="ADAL" clId="{BFA09A3D-6871-4CCE-ADFE-55371EFCD2BF}" dt="2020-09-15T14:34:28.582" v="97" actId="113"/>
      <pc:docMkLst>
        <pc:docMk/>
      </pc:docMkLst>
      <pc:sldChg chg="modSp mod">
        <pc:chgData name="William" userId="abd8c3f5-ff38-4d7d-ae66-861c24974fed" providerId="ADAL" clId="{BFA09A3D-6871-4CCE-ADFE-55371EFCD2BF}" dt="2020-09-15T14:31:52.789" v="75" actId="123"/>
        <pc:sldMkLst>
          <pc:docMk/>
          <pc:sldMk cId="4019928299" sldId="259"/>
        </pc:sldMkLst>
        <pc:spChg chg="mod">
          <ac:chgData name="William" userId="abd8c3f5-ff38-4d7d-ae66-861c24974fed" providerId="ADAL" clId="{BFA09A3D-6871-4CCE-ADFE-55371EFCD2BF}" dt="2020-09-15T14:31:52.789" v="75" actId="123"/>
          <ac:spMkLst>
            <pc:docMk/>
            <pc:sldMk cId="4019928299" sldId="259"/>
            <ac:spMk id="13" creationId="{2E47872E-59B4-41AA-B723-06747DABEF79}"/>
          </ac:spMkLst>
        </pc:spChg>
        <pc:picChg chg="mod">
          <ac:chgData name="William" userId="abd8c3f5-ff38-4d7d-ae66-861c24974fed" providerId="ADAL" clId="{BFA09A3D-6871-4CCE-ADFE-55371EFCD2BF}" dt="2020-09-15T14:27:06.091" v="35" actId="1076"/>
          <ac:picMkLst>
            <pc:docMk/>
            <pc:sldMk cId="4019928299" sldId="259"/>
            <ac:picMk id="3" creationId="{576278B3-9697-4846-8E71-B78EEF4F1252}"/>
          </ac:picMkLst>
        </pc:picChg>
        <pc:picChg chg="mod">
          <ac:chgData name="William" userId="abd8c3f5-ff38-4d7d-ae66-861c24974fed" providerId="ADAL" clId="{BFA09A3D-6871-4CCE-ADFE-55371EFCD2BF}" dt="2020-09-15T14:26:58.484" v="33" actId="1037"/>
          <ac:picMkLst>
            <pc:docMk/>
            <pc:sldMk cId="4019928299" sldId="259"/>
            <ac:picMk id="4" creationId="{9F2C756A-DEA9-41F2-8DDF-9296E4C03F57}"/>
          </ac:picMkLst>
        </pc:picChg>
        <pc:picChg chg="mod">
          <ac:chgData name="William" userId="abd8c3f5-ff38-4d7d-ae66-861c24974fed" providerId="ADAL" clId="{BFA09A3D-6871-4CCE-ADFE-55371EFCD2BF}" dt="2020-09-15T14:27:03.222" v="34" actId="1076"/>
          <ac:picMkLst>
            <pc:docMk/>
            <pc:sldMk cId="4019928299" sldId="259"/>
            <ac:picMk id="5" creationId="{AB21A5C9-76BA-4184-BB2C-FD572C6FD57F}"/>
          </ac:picMkLst>
        </pc:picChg>
        <pc:picChg chg="mod">
          <ac:chgData name="William" userId="abd8c3f5-ff38-4d7d-ae66-861c24974fed" providerId="ADAL" clId="{BFA09A3D-6871-4CCE-ADFE-55371EFCD2BF}" dt="2020-09-15T14:27:11.555" v="36" actId="1076"/>
          <ac:picMkLst>
            <pc:docMk/>
            <pc:sldMk cId="4019928299" sldId="259"/>
            <ac:picMk id="6" creationId="{A7CE5908-7434-4F88-9D9F-2717D94473BD}"/>
          </ac:picMkLst>
        </pc:picChg>
        <pc:picChg chg="mod">
          <ac:chgData name="William" userId="abd8c3f5-ff38-4d7d-ae66-861c24974fed" providerId="ADAL" clId="{BFA09A3D-6871-4CCE-ADFE-55371EFCD2BF}" dt="2020-09-15T14:27:15.028" v="37" actId="1076"/>
          <ac:picMkLst>
            <pc:docMk/>
            <pc:sldMk cId="4019928299" sldId="259"/>
            <ac:picMk id="7" creationId="{4C77A1F8-CA46-46A6-B47B-3ED9591FFC34}"/>
          </ac:picMkLst>
        </pc:picChg>
        <pc:picChg chg="mod">
          <ac:chgData name="William" userId="abd8c3f5-ff38-4d7d-ae66-861c24974fed" providerId="ADAL" clId="{BFA09A3D-6871-4CCE-ADFE-55371EFCD2BF}" dt="2020-09-15T14:27:18.284" v="38" actId="1076"/>
          <ac:picMkLst>
            <pc:docMk/>
            <pc:sldMk cId="4019928299" sldId="259"/>
            <ac:picMk id="8" creationId="{70DC06D7-1203-4642-BA9F-52A93E36FA20}"/>
          </ac:picMkLst>
        </pc:picChg>
        <pc:picChg chg="mod">
          <ac:chgData name="William" userId="abd8c3f5-ff38-4d7d-ae66-861c24974fed" providerId="ADAL" clId="{BFA09A3D-6871-4CCE-ADFE-55371EFCD2BF}" dt="2020-09-15T14:27:22.060" v="39" actId="1076"/>
          <ac:picMkLst>
            <pc:docMk/>
            <pc:sldMk cId="4019928299" sldId="259"/>
            <ac:picMk id="9" creationId="{3CD4929C-E5D1-4ABA-96A9-EBE6CC2E4B62}"/>
          </ac:picMkLst>
        </pc:picChg>
        <pc:picChg chg="mod">
          <ac:chgData name="William" userId="abd8c3f5-ff38-4d7d-ae66-861c24974fed" providerId="ADAL" clId="{BFA09A3D-6871-4CCE-ADFE-55371EFCD2BF}" dt="2020-09-15T14:27:26.084" v="40" actId="1076"/>
          <ac:picMkLst>
            <pc:docMk/>
            <pc:sldMk cId="4019928299" sldId="259"/>
            <ac:picMk id="10" creationId="{BF51EF53-9F2B-429B-A656-17E2CDE05A35}"/>
          </ac:picMkLst>
        </pc:picChg>
        <pc:picChg chg="mod">
          <ac:chgData name="William" userId="abd8c3f5-ff38-4d7d-ae66-861c24974fed" providerId="ADAL" clId="{BFA09A3D-6871-4CCE-ADFE-55371EFCD2BF}" dt="2020-09-15T14:26:58.484" v="33" actId="1037"/>
          <ac:picMkLst>
            <pc:docMk/>
            <pc:sldMk cId="4019928299" sldId="259"/>
            <ac:picMk id="11" creationId="{1ECC7DBF-D8D4-4947-98A7-E9DA1BB4BAD3}"/>
          </ac:picMkLst>
        </pc:picChg>
      </pc:sldChg>
      <pc:sldChg chg="modSp mod">
        <pc:chgData name="William" userId="abd8c3f5-ff38-4d7d-ae66-861c24974fed" providerId="ADAL" clId="{BFA09A3D-6871-4CCE-ADFE-55371EFCD2BF}" dt="2020-09-15T14:33:21.155" v="85" actId="1076"/>
        <pc:sldMkLst>
          <pc:docMk/>
          <pc:sldMk cId="1853063641" sldId="260"/>
        </pc:sldMkLst>
        <pc:spChg chg="mod">
          <ac:chgData name="William" userId="abd8c3f5-ff38-4d7d-ae66-861c24974fed" providerId="ADAL" clId="{BFA09A3D-6871-4CCE-ADFE-55371EFCD2BF}" dt="2020-09-15T14:32:12.983" v="78" actId="403"/>
          <ac:spMkLst>
            <pc:docMk/>
            <pc:sldMk cId="1853063641" sldId="260"/>
            <ac:spMk id="9" creationId="{BE9BE345-ADB8-4612-9863-37F18C1603BD}"/>
          </ac:spMkLst>
        </pc:spChg>
        <pc:spChg chg="mod">
          <ac:chgData name="William" userId="abd8c3f5-ff38-4d7d-ae66-861c24974fed" providerId="ADAL" clId="{BFA09A3D-6871-4CCE-ADFE-55371EFCD2BF}" dt="2020-09-15T14:32:12.983" v="78" actId="403"/>
          <ac:spMkLst>
            <pc:docMk/>
            <pc:sldMk cId="1853063641" sldId="260"/>
            <ac:spMk id="10" creationId="{5BEE1EB1-220B-4272-A1E0-7A6F37B48211}"/>
          </ac:spMkLst>
        </pc:spChg>
        <pc:spChg chg="mod">
          <ac:chgData name="William" userId="abd8c3f5-ff38-4d7d-ae66-861c24974fed" providerId="ADAL" clId="{BFA09A3D-6871-4CCE-ADFE-55371EFCD2BF}" dt="2020-09-15T14:32:12.983" v="78" actId="403"/>
          <ac:spMkLst>
            <pc:docMk/>
            <pc:sldMk cId="1853063641" sldId="260"/>
            <ac:spMk id="11" creationId="{4253699A-5B64-4E50-B2EE-D308308E377D}"/>
          </ac:spMkLst>
        </pc:spChg>
        <pc:spChg chg="mod">
          <ac:chgData name="William" userId="abd8c3f5-ff38-4d7d-ae66-861c24974fed" providerId="ADAL" clId="{BFA09A3D-6871-4CCE-ADFE-55371EFCD2BF}" dt="2020-09-15T14:32:12.983" v="78" actId="403"/>
          <ac:spMkLst>
            <pc:docMk/>
            <pc:sldMk cId="1853063641" sldId="260"/>
            <ac:spMk id="12" creationId="{F7F22A0B-4237-4BA9-B487-C552C7CD4ADF}"/>
          </ac:spMkLst>
        </pc:spChg>
        <pc:spChg chg="mod">
          <ac:chgData name="William" userId="abd8c3f5-ff38-4d7d-ae66-861c24974fed" providerId="ADAL" clId="{BFA09A3D-6871-4CCE-ADFE-55371EFCD2BF}" dt="2020-09-15T14:32:23.364" v="79" actId="1076"/>
          <ac:spMkLst>
            <pc:docMk/>
            <pc:sldMk cId="1853063641" sldId="260"/>
            <ac:spMk id="13" creationId="{57E9E167-5D10-429D-9FA3-A01A6F085679}"/>
          </ac:spMkLst>
        </pc:spChg>
        <pc:spChg chg="mod">
          <ac:chgData name="William" userId="abd8c3f5-ff38-4d7d-ae66-861c24974fed" providerId="ADAL" clId="{BFA09A3D-6871-4CCE-ADFE-55371EFCD2BF}" dt="2020-09-15T14:32:12.983" v="78" actId="403"/>
          <ac:spMkLst>
            <pc:docMk/>
            <pc:sldMk cId="1853063641" sldId="260"/>
            <ac:spMk id="14" creationId="{4B12FBBE-86EE-4707-BC36-FEC7EB14E4CA}"/>
          </ac:spMkLst>
        </pc:spChg>
        <pc:spChg chg="mod">
          <ac:chgData name="William" userId="abd8c3f5-ff38-4d7d-ae66-861c24974fed" providerId="ADAL" clId="{BFA09A3D-6871-4CCE-ADFE-55371EFCD2BF}" dt="2020-09-15T14:32:12.983" v="78" actId="403"/>
          <ac:spMkLst>
            <pc:docMk/>
            <pc:sldMk cId="1853063641" sldId="260"/>
            <ac:spMk id="15" creationId="{4F5F02C7-19A0-4437-80B2-4486E3FB01E4}"/>
          </ac:spMkLst>
        </pc:spChg>
        <pc:spChg chg="mod">
          <ac:chgData name="William" userId="abd8c3f5-ff38-4d7d-ae66-861c24974fed" providerId="ADAL" clId="{BFA09A3D-6871-4CCE-ADFE-55371EFCD2BF}" dt="2020-09-15T14:32:23.364" v="79" actId="1076"/>
          <ac:spMkLst>
            <pc:docMk/>
            <pc:sldMk cId="1853063641" sldId="260"/>
            <ac:spMk id="16" creationId="{E7AC43AF-40DC-4BBF-8797-8BA0C4D0AA8E}"/>
          </ac:spMkLst>
        </pc:spChg>
        <pc:spChg chg="mod">
          <ac:chgData name="William" userId="abd8c3f5-ff38-4d7d-ae66-861c24974fed" providerId="ADAL" clId="{BFA09A3D-6871-4CCE-ADFE-55371EFCD2BF}" dt="2020-09-15T14:32:23.364" v="79" actId="1076"/>
          <ac:spMkLst>
            <pc:docMk/>
            <pc:sldMk cId="1853063641" sldId="260"/>
            <ac:spMk id="17" creationId="{DE9EA2FD-A561-4018-8EC4-2E79B6D7CB84}"/>
          </ac:spMkLst>
        </pc:spChg>
        <pc:spChg chg="mod">
          <ac:chgData name="William" userId="abd8c3f5-ff38-4d7d-ae66-861c24974fed" providerId="ADAL" clId="{BFA09A3D-6871-4CCE-ADFE-55371EFCD2BF}" dt="2020-09-15T14:32:12.983" v="78" actId="403"/>
          <ac:spMkLst>
            <pc:docMk/>
            <pc:sldMk cId="1853063641" sldId="260"/>
            <ac:spMk id="18" creationId="{8154B5F7-AC31-443F-B252-61ADA284D504}"/>
          </ac:spMkLst>
        </pc:spChg>
        <pc:spChg chg="mod">
          <ac:chgData name="William" userId="abd8c3f5-ff38-4d7d-ae66-861c24974fed" providerId="ADAL" clId="{BFA09A3D-6871-4CCE-ADFE-55371EFCD2BF}" dt="2020-09-15T14:32:12.983" v="78" actId="403"/>
          <ac:spMkLst>
            <pc:docMk/>
            <pc:sldMk cId="1853063641" sldId="260"/>
            <ac:spMk id="19" creationId="{1C2CFE72-BA30-4843-8AF6-011ABCCD09C0}"/>
          </ac:spMkLst>
        </pc:spChg>
        <pc:spChg chg="mod">
          <ac:chgData name="William" userId="abd8c3f5-ff38-4d7d-ae66-861c24974fed" providerId="ADAL" clId="{BFA09A3D-6871-4CCE-ADFE-55371EFCD2BF}" dt="2020-09-15T14:32:23.364" v="79" actId="1076"/>
          <ac:spMkLst>
            <pc:docMk/>
            <pc:sldMk cId="1853063641" sldId="260"/>
            <ac:spMk id="20" creationId="{7EAFABA3-63D9-405A-99D3-E33C9DC157AC}"/>
          </ac:spMkLst>
        </pc:spChg>
        <pc:spChg chg="mod">
          <ac:chgData name="William" userId="abd8c3f5-ff38-4d7d-ae66-861c24974fed" providerId="ADAL" clId="{BFA09A3D-6871-4CCE-ADFE-55371EFCD2BF}" dt="2020-09-15T14:32:23.364" v="79" actId="1076"/>
          <ac:spMkLst>
            <pc:docMk/>
            <pc:sldMk cId="1853063641" sldId="260"/>
            <ac:spMk id="21" creationId="{A521B8D7-D7E0-4A82-9D21-8E30B9934828}"/>
          </ac:spMkLst>
        </pc:spChg>
        <pc:spChg chg="mod">
          <ac:chgData name="William" userId="abd8c3f5-ff38-4d7d-ae66-861c24974fed" providerId="ADAL" clId="{BFA09A3D-6871-4CCE-ADFE-55371EFCD2BF}" dt="2020-09-15T14:33:21.155" v="85" actId="1076"/>
          <ac:spMkLst>
            <pc:docMk/>
            <pc:sldMk cId="1853063641" sldId="260"/>
            <ac:spMk id="22" creationId="{B916290D-7D32-4375-89CD-D19CD7F26BCD}"/>
          </ac:spMkLst>
        </pc:spChg>
        <pc:picChg chg="mod">
          <ac:chgData name="William" userId="abd8c3f5-ff38-4d7d-ae66-861c24974fed" providerId="ADAL" clId="{BFA09A3D-6871-4CCE-ADFE-55371EFCD2BF}" dt="2020-09-15T14:32:23.364" v="79" actId="1076"/>
          <ac:picMkLst>
            <pc:docMk/>
            <pc:sldMk cId="1853063641" sldId="260"/>
            <ac:picMk id="5" creationId="{4D902354-ADF0-48FD-ABA4-98ECB65F7DE9}"/>
          </ac:picMkLst>
        </pc:picChg>
        <pc:picChg chg="mod">
          <ac:chgData name="William" userId="abd8c3f5-ff38-4d7d-ae66-861c24974fed" providerId="ADAL" clId="{BFA09A3D-6871-4CCE-ADFE-55371EFCD2BF}" dt="2020-09-15T14:32:04.292" v="76" actId="1076"/>
          <ac:picMkLst>
            <pc:docMk/>
            <pc:sldMk cId="1853063641" sldId="260"/>
            <ac:picMk id="6" creationId="{1AD3DFE9-A2BF-49D7-AEEE-32F3C2D29027}"/>
          </ac:picMkLst>
        </pc:picChg>
      </pc:sldChg>
      <pc:sldChg chg="modSp mod">
        <pc:chgData name="William" userId="abd8c3f5-ff38-4d7d-ae66-861c24974fed" providerId="ADAL" clId="{BFA09A3D-6871-4CCE-ADFE-55371EFCD2BF}" dt="2020-09-15T14:34:28.582" v="97" actId="113"/>
        <pc:sldMkLst>
          <pc:docMk/>
          <pc:sldMk cId="3108368087" sldId="261"/>
        </pc:sldMkLst>
        <pc:spChg chg="mod">
          <ac:chgData name="William" userId="abd8c3f5-ff38-4d7d-ae66-861c24974fed" providerId="ADAL" clId="{BFA09A3D-6871-4CCE-ADFE-55371EFCD2BF}" dt="2020-09-15T14:29:48.862" v="62" actId="554"/>
          <ac:spMkLst>
            <pc:docMk/>
            <pc:sldMk cId="3108368087" sldId="261"/>
            <ac:spMk id="4" creationId="{587C8B08-1AE4-4DE0-99AC-917357539E8A}"/>
          </ac:spMkLst>
        </pc:spChg>
        <pc:spChg chg="mod">
          <ac:chgData name="William" userId="abd8c3f5-ff38-4d7d-ae66-861c24974fed" providerId="ADAL" clId="{BFA09A3D-6871-4CCE-ADFE-55371EFCD2BF}" dt="2020-09-15T14:29:48.862" v="62" actId="554"/>
          <ac:spMkLst>
            <pc:docMk/>
            <pc:sldMk cId="3108368087" sldId="261"/>
            <ac:spMk id="9" creationId="{47CC8703-EAFF-4AD1-BA06-E0C5BB689A31}"/>
          </ac:spMkLst>
        </pc:spChg>
        <pc:spChg chg="mod">
          <ac:chgData name="William" userId="abd8c3f5-ff38-4d7d-ae66-861c24974fed" providerId="ADAL" clId="{BFA09A3D-6871-4CCE-ADFE-55371EFCD2BF}" dt="2020-09-15T14:28:55.175" v="56" actId="20577"/>
          <ac:spMkLst>
            <pc:docMk/>
            <pc:sldMk cId="3108368087" sldId="261"/>
            <ac:spMk id="10" creationId="{9E22969A-F3FD-4189-A09E-18E63452E411}"/>
          </ac:spMkLst>
        </pc:spChg>
        <pc:spChg chg="mod">
          <ac:chgData name="William" userId="abd8c3f5-ff38-4d7d-ae66-861c24974fed" providerId="ADAL" clId="{BFA09A3D-6871-4CCE-ADFE-55371EFCD2BF}" dt="2020-09-15T14:34:28.582" v="97" actId="113"/>
          <ac:spMkLst>
            <pc:docMk/>
            <pc:sldMk cId="3108368087" sldId="261"/>
            <ac:spMk id="11" creationId="{252F948A-1040-40AF-8667-C72BEA0A1625}"/>
          </ac:spMkLst>
        </pc:spChg>
        <pc:graphicFrameChg chg="mod modGraphic">
          <ac:chgData name="William" userId="abd8c3f5-ff38-4d7d-ae66-861c24974fed" providerId="ADAL" clId="{BFA09A3D-6871-4CCE-ADFE-55371EFCD2BF}" dt="2020-09-15T14:28:51.077" v="54" actId="1076"/>
          <ac:graphicFrameMkLst>
            <pc:docMk/>
            <pc:sldMk cId="3108368087" sldId="261"/>
            <ac:graphicFrameMk id="2" creationId="{0638A2FF-F767-4BAC-861A-6A520DE63844}"/>
          </ac:graphicFrameMkLst>
        </pc:graphicFrameChg>
      </pc:sldChg>
    </pc:docChg>
  </pc:docChgLst>
  <pc:docChgLst>
    <pc:chgData name="William Cathery" userId="abd8c3f5-ff38-4d7d-ae66-861c24974fed" providerId="ADAL" clId="{BA629DC8-64EE-4B7D-90B0-C0B554E1FD54}"/>
    <pc:docChg chg="undo custSel addSld modSld sldOrd">
      <pc:chgData name="William Cathery" userId="abd8c3f5-ff38-4d7d-ae66-861c24974fed" providerId="ADAL" clId="{BA629DC8-64EE-4B7D-90B0-C0B554E1FD54}" dt="2020-11-26T11:23:16.848" v="634" actId="20577"/>
      <pc:docMkLst>
        <pc:docMk/>
      </pc:docMkLst>
      <pc:sldChg chg="addSp delSp modSp mod">
        <pc:chgData name="William Cathery" userId="abd8c3f5-ff38-4d7d-ae66-861c24974fed" providerId="ADAL" clId="{BA629DC8-64EE-4B7D-90B0-C0B554E1FD54}" dt="2020-11-26T11:17:38.589" v="244" actId="20577"/>
        <pc:sldMkLst>
          <pc:docMk/>
          <pc:sldMk cId="1853063641" sldId="260"/>
        </pc:sldMkLst>
        <pc:spChg chg="mod">
          <ac:chgData name="William Cathery" userId="abd8c3f5-ff38-4d7d-ae66-861c24974fed" providerId="ADAL" clId="{BA629DC8-64EE-4B7D-90B0-C0B554E1FD54}" dt="2020-11-26T11:17:38.589" v="244" actId="20577"/>
          <ac:spMkLst>
            <pc:docMk/>
            <pc:sldMk cId="1853063641" sldId="260"/>
            <ac:spMk id="22" creationId="{B916290D-7D32-4375-89CD-D19CD7F26BCD}"/>
          </ac:spMkLst>
        </pc:spChg>
        <pc:spChg chg="add mod">
          <ac:chgData name="William Cathery" userId="abd8c3f5-ff38-4d7d-ae66-861c24974fed" providerId="ADAL" clId="{BA629DC8-64EE-4B7D-90B0-C0B554E1FD54}" dt="2020-11-26T09:36:01.278" v="7" actId="1076"/>
          <ac:spMkLst>
            <pc:docMk/>
            <pc:sldMk cId="1853063641" sldId="260"/>
            <ac:spMk id="23" creationId="{EABBFDB2-851F-4AE1-887B-20D03D1E6368}"/>
          </ac:spMkLst>
        </pc:spChg>
        <pc:spChg chg="add mod">
          <ac:chgData name="William Cathery" userId="abd8c3f5-ff38-4d7d-ae66-861c24974fed" providerId="ADAL" clId="{BA629DC8-64EE-4B7D-90B0-C0B554E1FD54}" dt="2020-11-26T09:36:08.123" v="11" actId="20577"/>
          <ac:spMkLst>
            <pc:docMk/>
            <pc:sldMk cId="1853063641" sldId="260"/>
            <ac:spMk id="24" creationId="{9E98B1D7-3AEC-4E04-AA23-DCD62309AF64}"/>
          </ac:spMkLst>
        </pc:spChg>
        <pc:spChg chg="add mod">
          <ac:chgData name="William Cathery" userId="abd8c3f5-ff38-4d7d-ae66-861c24974fed" providerId="ADAL" clId="{BA629DC8-64EE-4B7D-90B0-C0B554E1FD54}" dt="2020-11-26T09:36:30.294" v="20" actId="20577"/>
          <ac:spMkLst>
            <pc:docMk/>
            <pc:sldMk cId="1853063641" sldId="260"/>
            <ac:spMk id="25" creationId="{1FD2AA83-6184-43F4-B595-23B7377D14F2}"/>
          </ac:spMkLst>
        </pc:spChg>
        <pc:spChg chg="add mod">
          <ac:chgData name="William Cathery" userId="abd8c3f5-ff38-4d7d-ae66-861c24974fed" providerId="ADAL" clId="{BA629DC8-64EE-4B7D-90B0-C0B554E1FD54}" dt="2020-11-26T09:36:41.783" v="24" actId="20577"/>
          <ac:spMkLst>
            <pc:docMk/>
            <pc:sldMk cId="1853063641" sldId="260"/>
            <ac:spMk id="26" creationId="{1B353315-0CB7-4F94-8EEA-D4A8C61F6C62}"/>
          </ac:spMkLst>
        </pc:spChg>
        <pc:spChg chg="add mod">
          <ac:chgData name="William Cathery" userId="abd8c3f5-ff38-4d7d-ae66-861c24974fed" providerId="ADAL" clId="{BA629DC8-64EE-4B7D-90B0-C0B554E1FD54}" dt="2020-11-26T09:39:54.174" v="58" actId="1076"/>
          <ac:spMkLst>
            <pc:docMk/>
            <pc:sldMk cId="1853063641" sldId="260"/>
            <ac:spMk id="27" creationId="{0AEC2F13-3AD3-44A9-86CE-0B490A6D310F}"/>
          </ac:spMkLst>
        </pc:spChg>
        <pc:spChg chg="add del mod">
          <ac:chgData name="William Cathery" userId="abd8c3f5-ff38-4d7d-ae66-861c24974fed" providerId="ADAL" clId="{BA629DC8-64EE-4B7D-90B0-C0B554E1FD54}" dt="2020-11-26T09:39:08.611" v="52" actId="478"/>
          <ac:spMkLst>
            <pc:docMk/>
            <pc:sldMk cId="1853063641" sldId="260"/>
            <ac:spMk id="28" creationId="{D471AD2F-363A-430C-8E16-AB542A41A3F5}"/>
          </ac:spMkLst>
        </pc:spChg>
        <pc:spChg chg="add del mod">
          <ac:chgData name="William Cathery" userId="abd8c3f5-ff38-4d7d-ae66-861c24974fed" providerId="ADAL" clId="{BA629DC8-64EE-4B7D-90B0-C0B554E1FD54}" dt="2020-11-26T09:39:08.611" v="52" actId="478"/>
          <ac:spMkLst>
            <pc:docMk/>
            <pc:sldMk cId="1853063641" sldId="260"/>
            <ac:spMk id="29" creationId="{03635DFC-1592-4E41-882E-90B19999141B}"/>
          </ac:spMkLst>
        </pc:spChg>
        <pc:spChg chg="add del mod">
          <ac:chgData name="William Cathery" userId="abd8c3f5-ff38-4d7d-ae66-861c24974fed" providerId="ADAL" clId="{BA629DC8-64EE-4B7D-90B0-C0B554E1FD54}" dt="2020-11-26T09:39:11.037" v="53" actId="478"/>
          <ac:spMkLst>
            <pc:docMk/>
            <pc:sldMk cId="1853063641" sldId="260"/>
            <ac:spMk id="30" creationId="{D67DC424-1FE8-4D3A-BB82-AB49D4128A72}"/>
          </ac:spMkLst>
        </pc:spChg>
        <pc:spChg chg="add del mod">
          <ac:chgData name="William Cathery" userId="abd8c3f5-ff38-4d7d-ae66-861c24974fed" providerId="ADAL" clId="{BA629DC8-64EE-4B7D-90B0-C0B554E1FD54}" dt="2020-11-26T09:39:08.611" v="52" actId="478"/>
          <ac:spMkLst>
            <pc:docMk/>
            <pc:sldMk cId="1853063641" sldId="260"/>
            <ac:spMk id="31" creationId="{B79803C6-9ECA-4192-9FF6-7EECD7656ECB}"/>
          </ac:spMkLst>
        </pc:spChg>
        <pc:spChg chg="add mod">
          <ac:chgData name="William Cathery" userId="abd8c3f5-ff38-4d7d-ae66-861c24974fed" providerId="ADAL" clId="{BA629DC8-64EE-4B7D-90B0-C0B554E1FD54}" dt="2020-11-26T09:38:47.837" v="46" actId="554"/>
          <ac:spMkLst>
            <pc:docMk/>
            <pc:sldMk cId="1853063641" sldId="260"/>
            <ac:spMk id="32" creationId="{77919009-C757-4F5A-806C-57688D6E3BAB}"/>
          </ac:spMkLst>
        </pc:spChg>
        <pc:spChg chg="add mod">
          <ac:chgData name="William Cathery" userId="abd8c3f5-ff38-4d7d-ae66-861c24974fed" providerId="ADAL" clId="{BA629DC8-64EE-4B7D-90B0-C0B554E1FD54}" dt="2020-11-26T09:39:01.668" v="49" actId="408"/>
          <ac:spMkLst>
            <pc:docMk/>
            <pc:sldMk cId="1853063641" sldId="260"/>
            <ac:spMk id="33" creationId="{95DDA704-6BBA-44EE-A9F5-7B9C042FD257}"/>
          </ac:spMkLst>
        </pc:spChg>
        <pc:spChg chg="add mod">
          <ac:chgData name="William Cathery" userId="abd8c3f5-ff38-4d7d-ae66-861c24974fed" providerId="ADAL" clId="{BA629DC8-64EE-4B7D-90B0-C0B554E1FD54}" dt="2020-11-26T09:39:01.668" v="49" actId="408"/>
          <ac:spMkLst>
            <pc:docMk/>
            <pc:sldMk cId="1853063641" sldId="260"/>
            <ac:spMk id="34" creationId="{E307A838-E644-4A96-8437-41258DEB0F15}"/>
          </ac:spMkLst>
        </pc:spChg>
        <pc:spChg chg="add mod">
          <ac:chgData name="William Cathery" userId="abd8c3f5-ff38-4d7d-ae66-861c24974fed" providerId="ADAL" clId="{BA629DC8-64EE-4B7D-90B0-C0B554E1FD54}" dt="2020-11-26T09:38:47.837" v="46" actId="554"/>
          <ac:spMkLst>
            <pc:docMk/>
            <pc:sldMk cId="1853063641" sldId="260"/>
            <ac:spMk id="35" creationId="{A522DD78-01FD-47D6-ADE4-0C400D1A08B4}"/>
          </ac:spMkLst>
        </pc:spChg>
        <pc:spChg chg="add mod">
          <ac:chgData name="William Cathery" userId="abd8c3f5-ff38-4d7d-ae66-861c24974fed" providerId="ADAL" clId="{BA629DC8-64EE-4B7D-90B0-C0B554E1FD54}" dt="2020-11-26T09:39:54.174" v="58" actId="1076"/>
          <ac:spMkLst>
            <pc:docMk/>
            <pc:sldMk cId="1853063641" sldId="260"/>
            <ac:spMk id="36" creationId="{C80A53CC-7FC9-4B61-B13E-5B5CBFEDCE69}"/>
          </ac:spMkLst>
        </pc:spChg>
        <pc:spChg chg="add mod">
          <ac:chgData name="William Cathery" userId="abd8c3f5-ff38-4d7d-ae66-861c24974fed" providerId="ADAL" clId="{BA629DC8-64EE-4B7D-90B0-C0B554E1FD54}" dt="2020-11-26T09:39:54.174" v="58" actId="1076"/>
          <ac:spMkLst>
            <pc:docMk/>
            <pc:sldMk cId="1853063641" sldId="260"/>
            <ac:spMk id="37" creationId="{63781F34-B763-420F-8FFF-25470522A2BD}"/>
          </ac:spMkLst>
        </pc:spChg>
        <pc:spChg chg="add mod">
          <ac:chgData name="William Cathery" userId="abd8c3f5-ff38-4d7d-ae66-861c24974fed" providerId="ADAL" clId="{BA629DC8-64EE-4B7D-90B0-C0B554E1FD54}" dt="2020-11-26T09:39:54.174" v="58" actId="1076"/>
          <ac:spMkLst>
            <pc:docMk/>
            <pc:sldMk cId="1853063641" sldId="260"/>
            <ac:spMk id="38" creationId="{06AB5B3C-0F88-4938-A871-F543CE56F266}"/>
          </ac:spMkLst>
        </pc:spChg>
        <pc:spChg chg="add mod">
          <ac:chgData name="William Cathery" userId="abd8c3f5-ff38-4d7d-ae66-861c24974fed" providerId="ADAL" clId="{BA629DC8-64EE-4B7D-90B0-C0B554E1FD54}" dt="2020-11-26T09:39:54.174" v="58" actId="1076"/>
          <ac:spMkLst>
            <pc:docMk/>
            <pc:sldMk cId="1853063641" sldId="260"/>
            <ac:spMk id="39" creationId="{E2E30252-EFB7-4EE7-B07A-8BDB9ADAB21B}"/>
          </ac:spMkLst>
        </pc:spChg>
        <pc:spChg chg="add mod">
          <ac:chgData name="William Cathery" userId="abd8c3f5-ff38-4d7d-ae66-861c24974fed" providerId="ADAL" clId="{BA629DC8-64EE-4B7D-90B0-C0B554E1FD54}" dt="2020-11-26T09:39:47.023" v="57" actId="1076"/>
          <ac:spMkLst>
            <pc:docMk/>
            <pc:sldMk cId="1853063641" sldId="260"/>
            <ac:spMk id="40" creationId="{30F1F48A-C49F-47B5-A937-C274A4ECF646}"/>
          </ac:spMkLst>
        </pc:spChg>
        <pc:spChg chg="add mod">
          <ac:chgData name="William Cathery" userId="abd8c3f5-ff38-4d7d-ae66-861c24974fed" providerId="ADAL" clId="{BA629DC8-64EE-4B7D-90B0-C0B554E1FD54}" dt="2020-11-26T09:39:47.023" v="57" actId="1076"/>
          <ac:spMkLst>
            <pc:docMk/>
            <pc:sldMk cId="1853063641" sldId="260"/>
            <ac:spMk id="41" creationId="{B8B9E40D-0BDE-4720-BBCB-792B6AF6EA2C}"/>
          </ac:spMkLst>
        </pc:spChg>
        <pc:spChg chg="add mod">
          <ac:chgData name="William Cathery" userId="abd8c3f5-ff38-4d7d-ae66-861c24974fed" providerId="ADAL" clId="{BA629DC8-64EE-4B7D-90B0-C0B554E1FD54}" dt="2020-11-26T09:39:47.023" v="57" actId="1076"/>
          <ac:spMkLst>
            <pc:docMk/>
            <pc:sldMk cId="1853063641" sldId="260"/>
            <ac:spMk id="42" creationId="{9F00EB86-23C0-4929-BDBF-77BBC97EB24A}"/>
          </ac:spMkLst>
        </pc:spChg>
        <pc:spChg chg="add mod">
          <ac:chgData name="William Cathery" userId="abd8c3f5-ff38-4d7d-ae66-861c24974fed" providerId="ADAL" clId="{BA629DC8-64EE-4B7D-90B0-C0B554E1FD54}" dt="2020-11-26T09:39:47.023" v="57" actId="1076"/>
          <ac:spMkLst>
            <pc:docMk/>
            <pc:sldMk cId="1853063641" sldId="260"/>
            <ac:spMk id="43" creationId="{CE840F3A-91E6-4F2A-9C2C-F08237EF8553}"/>
          </ac:spMkLst>
        </pc:spChg>
        <pc:picChg chg="add mod modCrop">
          <ac:chgData name="William Cathery" userId="abd8c3f5-ff38-4d7d-ae66-861c24974fed" providerId="ADAL" clId="{BA629DC8-64EE-4B7D-90B0-C0B554E1FD54}" dt="2020-11-26T09:39:54.174" v="58" actId="1076"/>
          <ac:picMkLst>
            <pc:docMk/>
            <pc:sldMk cId="1853063641" sldId="260"/>
            <ac:picMk id="2" creationId="{D8F8B6C3-71D5-43A0-BBBF-82E01CD18F2E}"/>
          </ac:picMkLst>
        </pc:picChg>
        <pc:picChg chg="add mod modCrop">
          <ac:chgData name="William Cathery" userId="abd8c3f5-ff38-4d7d-ae66-861c24974fed" providerId="ADAL" clId="{BA629DC8-64EE-4B7D-90B0-C0B554E1FD54}" dt="2020-11-26T09:38:32.006" v="43" actId="1076"/>
          <ac:picMkLst>
            <pc:docMk/>
            <pc:sldMk cId="1853063641" sldId="260"/>
            <ac:picMk id="3" creationId="{05944004-9D64-4517-8C40-C86F06DCECE2}"/>
          </ac:picMkLst>
        </pc:picChg>
        <pc:picChg chg="mod">
          <ac:chgData name="William Cathery" userId="abd8c3f5-ff38-4d7d-ae66-861c24974fed" providerId="ADAL" clId="{BA629DC8-64EE-4B7D-90B0-C0B554E1FD54}" dt="2020-11-26T09:39:25.766" v="55" actId="1076"/>
          <ac:picMkLst>
            <pc:docMk/>
            <pc:sldMk cId="1853063641" sldId="260"/>
            <ac:picMk id="6" creationId="{1AD3DFE9-A2BF-49D7-AEEE-32F3C2D29027}"/>
          </ac:picMkLst>
        </pc:picChg>
      </pc:sldChg>
      <pc:sldChg chg="modSp mod">
        <pc:chgData name="William Cathery" userId="abd8c3f5-ff38-4d7d-ae66-861c24974fed" providerId="ADAL" clId="{BA629DC8-64EE-4B7D-90B0-C0B554E1FD54}" dt="2020-11-26T11:17:42.454" v="246" actId="20577"/>
        <pc:sldMkLst>
          <pc:docMk/>
          <pc:sldMk cId="3108368087" sldId="261"/>
        </pc:sldMkLst>
        <pc:spChg chg="mod">
          <ac:chgData name="William Cathery" userId="abd8c3f5-ff38-4d7d-ae66-861c24974fed" providerId="ADAL" clId="{BA629DC8-64EE-4B7D-90B0-C0B554E1FD54}" dt="2020-11-26T11:17:42.454" v="246" actId="20577"/>
          <ac:spMkLst>
            <pc:docMk/>
            <pc:sldMk cId="3108368087" sldId="261"/>
            <ac:spMk id="11" creationId="{252F948A-1040-40AF-8667-C72BEA0A1625}"/>
          </ac:spMkLst>
        </pc:spChg>
      </pc:sldChg>
      <pc:sldChg chg="addSp delSp modSp add mod ord">
        <pc:chgData name="William Cathery" userId="abd8c3f5-ff38-4d7d-ae66-861c24974fed" providerId="ADAL" clId="{BA629DC8-64EE-4B7D-90B0-C0B554E1FD54}" dt="2020-11-26T11:17:47.398" v="248" actId="20577"/>
        <pc:sldMkLst>
          <pc:docMk/>
          <pc:sldMk cId="384623300" sldId="262"/>
        </pc:sldMkLst>
        <pc:spChg chg="mod">
          <ac:chgData name="William Cathery" userId="abd8c3f5-ff38-4d7d-ae66-861c24974fed" providerId="ADAL" clId="{BA629DC8-64EE-4B7D-90B0-C0B554E1FD54}" dt="2020-11-26T11:17:47.398" v="248" actId="20577"/>
          <ac:spMkLst>
            <pc:docMk/>
            <pc:sldMk cId="384623300" sldId="262"/>
            <ac:spMk id="13" creationId="{2E47872E-59B4-41AA-B723-06747DABEF79}"/>
          </ac:spMkLst>
        </pc:spChg>
        <pc:spChg chg="del mod topLvl">
          <ac:chgData name="William Cathery" userId="abd8c3f5-ff38-4d7d-ae66-861c24974fed" providerId="ADAL" clId="{BA629DC8-64EE-4B7D-90B0-C0B554E1FD54}" dt="2020-11-26T09:46:38.196" v="198" actId="478"/>
          <ac:spMkLst>
            <pc:docMk/>
            <pc:sldMk cId="384623300" sldId="262"/>
            <ac:spMk id="16" creationId="{E8E6DAFF-8E88-4EB9-8C3D-D80A684A3EF7}"/>
          </ac:spMkLst>
        </pc:spChg>
        <pc:spChg chg="del mod topLvl">
          <ac:chgData name="William Cathery" userId="abd8c3f5-ff38-4d7d-ae66-861c24974fed" providerId="ADAL" clId="{BA629DC8-64EE-4B7D-90B0-C0B554E1FD54}" dt="2020-11-26T09:46:39.998" v="199" actId="478"/>
          <ac:spMkLst>
            <pc:docMk/>
            <pc:sldMk cId="384623300" sldId="262"/>
            <ac:spMk id="17" creationId="{427EA810-0FCF-43D1-B8A9-0034B0BEC4C3}"/>
          </ac:spMkLst>
        </pc:spChg>
        <pc:spChg chg="del mod topLvl">
          <ac:chgData name="William Cathery" userId="abd8c3f5-ff38-4d7d-ae66-861c24974fed" providerId="ADAL" clId="{BA629DC8-64EE-4B7D-90B0-C0B554E1FD54}" dt="2020-11-26T09:46:36.382" v="197" actId="478"/>
          <ac:spMkLst>
            <pc:docMk/>
            <pc:sldMk cId="384623300" sldId="262"/>
            <ac:spMk id="18" creationId="{E09864E0-EBD5-4EC1-BD61-8BFC26D0F450}"/>
          </ac:spMkLst>
        </pc:spChg>
        <pc:spChg chg="add mod">
          <ac:chgData name="William Cathery" userId="abd8c3f5-ff38-4d7d-ae66-861c24974fed" providerId="ADAL" clId="{BA629DC8-64EE-4B7D-90B0-C0B554E1FD54}" dt="2020-11-26T09:47:26.968" v="210" actId="1076"/>
          <ac:spMkLst>
            <pc:docMk/>
            <pc:sldMk cId="384623300" sldId="262"/>
            <ac:spMk id="22" creationId="{7A6BE58F-8844-4D76-8E71-01788EF1CAE9}"/>
          </ac:spMkLst>
        </pc:spChg>
        <pc:spChg chg="add mod">
          <ac:chgData name="William Cathery" userId="abd8c3f5-ff38-4d7d-ae66-861c24974fed" providerId="ADAL" clId="{BA629DC8-64EE-4B7D-90B0-C0B554E1FD54}" dt="2020-11-26T09:47:32.615" v="214" actId="20577"/>
          <ac:spMkLst>
            <pc:docMk/>
            <pc:sldMk cId="384623300" sldId="262"/>
            <ac:spMk id="23" creationId="{3880915C-F039-431F-B2D7-0E5982A6B34F}"/>
          </ac:spMkLst>
        </pc:spChg>
        <pc:spChg chg="add mod">
          <ac:chgData name="William Cathery" userId="abd8c3f5-ff38-4d7d-ae66-861c24974fed" providerId="ADAL" clId="{BA629DC8-64EE-4B7D-90B0-C0B554E1FD54}" dt="2020-11-26T09:47:40.255" v="218" actId="20577"/>
          <ac:spMkLst>
            <pc:docMk/>
            <pc:sldMk cId="384623300" sldId="262"/>
            <ac:spMk id="24" creationId="{5593358A-38CC-4F76-B06F-CB27F4B90E71}"/>
          </ac:spMkLst>
        </pc:spChg>
        <pc:spChg chg="add del mod">
          <ac:chgData name="William Cathery" userId="abd8c3f5-ff38-4d7d-ae66-861c24974fed" providerId="ADAL" clId="{BA629DC8-64EE-4B7D-90B0-C0B554E1FD54}" dt="2020-11-26T09:49:26.366" v="225" actId="478"/>
          <ac:spMkLst>
            <pc:docMk/>
            <pc:sldMk cId="384623300" sldId="262"/>
            <ac:spMk id="25" creationId="{EFE7603C-F559-46BC-AD1B-74AE28F1E0CE}"/>
          </ac:spMkLst>
        </pc:spChg>
        <pc:grpChg chg="add del mod">
          <ac:chgData name="William Cathery" userId="abd8c3f5-ff38-4d7d-ae66-861c24974fed" providerId="ADAL" clId="{BA629DC8-64EE-4B7D-90B0-C0B554E1FD54}" dt="2020-11-26T09:46:29.809" v="195" actId="165"/>
          <ac:grpSpMkLst>
            <pc:docMk/>
            <pc:sldMk cId="384623300" sldId="262"/>
            <ac:grpSpMk id="14" creationId="{64CD5D2A-7353-4267-8DCB-36CC3DC03B7D}"/>
          </ac:grpSpMkLst>
        </pc:grpChg>
        <pc:grpChg chg="del mod topLvl">
          <ac:chgData name="William Cathery" userId="abd8c3f5-ff38-4d7d-ae66-861c24974fed" providerId="ADAL" clId="{BA629DC8-64EE-4B7D-90B0-C0B554E1FD54}" dt="2020-11-26T09:46:45.483" v="200" actId="165"/>
          <ac:grpSpMkLst>
            <pc:docMk/>
            <pc:sldMk cId="384623300" sldId="262"/>
            <ac:grpSpMk id="15" creationId="{9C39D170-06B8-4914-A797-9A5E0005774C}"/>
          </ac:grpSpMkLst>
        </pc:grpChg>
        <pc:picChg chg="add del mod">
          <ac:chgData name="William Cathery" userId="abd8c3f5-ff38-4d7d-ae66-861c24974fed" providerId="ADAL" clId="{BA629DC8-64EE-4B7D-90B0-C0B554E1FD54}" dt="2020-11-26T09:46:22.339" v="192"/>
          <ac:picMkLst>
            <pc:docMk/>
            <pc:sldMk cId="384623300" sldId="262"/>
            <ac:picMk id="2" creationId="{C073423E-F401-49B2-BD9A-7DA0A84572F5}"/>
          </ac:picMkLst>
        </pc:picChg>
        <pc:picChg chg="del">
          <ac:chgData name="William Cathery" userId="abd8c3f5-ff38-4d7d-ae66-861c24974fed" providerId="ADAL" clId="{BA629DC8-64EE-4B7D-90B0-C0B554E1FD54}" dt="2020-11-26T09:46:17.341" v="190" actId="478"/>
          <ac:picMkLst>
            <pc:docMk/>
            <pc:sldMk cId="384623300" sldId="262"/>
            <ac:picMk id="3" creationId="{576278B3-9697-4846-8E71-B78EEF4F1252}"/>
          </ac:picMkLst>
        </pc:picChg>
        <pc:picChg chg="del">
          <ac:chgData name="William Cathery" userId="abd8c3f5-ff38-4d7d-ae66-861c24974fed" providerId="ADAL" clId="{BA629DC8-64EE-4B7D-90B0-C0B554E1FD54}" dt="2020-11-26T09:46:17.341" v="190" actId="478"/>
          <ac:picMkLst>
            <pc:docMk/>
            <pc:sldMk cId="384623300" sldId="262"/>
            <ac:picMk id="4" creationId="{9F2C756A-DEA9-41F2-8DDF-9296E4C03F57}"/>
          </ac:picMkLst>
        </pc:picChg>
        <pc:picChg chg="del">
          <ac:chgData name="William Cathery" userId="abd8c3f5-ff38-4d7d-ae66-861c24974fed" providerId="ADAL" clId="{BA629DC8-64EE-4B7D-90B0-C0B554E1FD54}" dt="2020-11-26T09:46:17.341" v="190" actId="478"/>
          <ac:picMkLst>
            <pc:docMk/>
            <pc:sldMk cId="384623300" sldId="262"/>
            <ac:picMk id="5" creationId="{AB21A5C9-76BA-4184-BB2C-FD572C6FD57F}"/>
          </ac:picMkLst>
        </pc:picChg>
        <pc:picChg chg="del">
          <ac:chgData name="William Cathery" userId="abd8c3f5-ff38-4d7d-ae66-861c24974fed" providerId="ADAL" clId="{BA629DC8-64EE-4B7D-90B0-C0B554E1FD54}" dt="2020-11-26T09:46:17.341" v="190" actId="478"/>
          <ac:picMkLst>
            <pc:docMk/>
            <pc:sldMk cId="384623300" sldId="262"/>
            <ac:picMk id="6" creationId="{A7CE5908-7434-4F88-9D9F-2717D94473BD}"/>
          </ac:picMkLst>
        </pc:picChg>
        <pc:picChg chg="del">
          <ac:chgData name="William Cathery" userId="abd8c3f5-ff38-4d7d-ae66-861c24974fed" providerId="ADAL" clId="{BA629DC8-64EE-4B7D-90B0-C0B554E1FD54}" dt="2020-11-26T09:46:17.341" v="190" actId="478"/>
          <ac:picMkLst>
            <pc:docMk/>
            <pc:sldMk cId="384623300" sldId="262"/>
            <ac:picMk id="7" creationId="{4C77A1F8-CA46-46A6-B47B-3ED9591FFC34}"/>
          </ac:picMkLst>
        </pc:picChg>
        <pc:picChg chg="del">
          <ac:chgData name="William Cathery" userId="abd8c3f5-ff38-4d7d-ae66-861c24974fed" providerId="ADAL" clId="{BA629DC8-64EE-4B7D-90B0-C0B554E1FD54}" dt="2020-11-26T09:46:17.341" v="190" actId="478"/>
          <ac:picMkLst>
            <pc:docMk/>
            <pc:sldMk cId="384623300" sldId="262"/>
            <ac:picMk id="8" creationId="{70DC06D7-1203-4642-BA9F-52A93E36FA20}"/>
          </ac:picMkLst>
        </pc:picChg>
        <pc:picChg chg="del">
          <ac:chgData name="William Cathery" userId="abd8c3f5-ff38-4d7d-ae66-861c24974fed" providerId="ADAL" clId="{BA629DC8-64EE-4B7D-90B0-C0B554E1FD54}" dt="2020-11-26T09:46:17.341" v="190" actId="478"/>
          <ac:picMkLst>
            <pc:docMk/>
            <pc:sldMk cId="384623300" sldId="262"/>
            <ac:picMk id="9" creationId="{3CD4929C-E5D1-4ABA-96A9-EBE6CC2E4B62}"/>
          </ac:picMkLst>
        </pc:picChg>
        <pc:picChg chg="del">
          <ac:chgData name="William Cathery" userId="abd8c3f5-ff38-4d7d-ae66-861c24974fed" providerId="ADAL" clId="{BA629DC8-64EE-4B7D-90B0-C0B554E1FD54}" dt="2020-11-26T09:46:17.341" v="190" actId="478"/>
          <ac:picMkLst>
            <pc:docMk/>
            <pc:sldMk cId="384623300" sldId="262"/>
            <ac:picMk id="10" creationId="{BF51EF53-9F2B-429B-A656-17E2CDE05A35}"/>
          </ac:picMkLst>
        </pc:picChg>
        <pc:picChg chg="del">
          <ac:chgData name="William Cathery" userId="abd8c3f5-ff38-4d7d-ae66-861c24974fed" providerId="ADAL" clId="{BA629DC8-64EE-4B7D-90B0-C0B554E1FD54}" dt="2020-11-26T09:46:17.341" v="190" actId="478"/>
          <ac:picMkLst>
            <pc:docMk/>
            <pc:sldMk cId="384623300" sldId="262"/>
            <ac:picMk id="11" creationId="{1ECC7DBF-D8D4-4947-98A7-E9DA1BB4BAD3}"/>
          </ac:picMkLst>
        </pc:picChg>
        <pc:picChg chg="mod topLvl">
          <ac:chgData name="William Cathery" userId="abd8c3f5-ff38-4d7d-ae66-861c24974fed" providerId="ADAL" clId="{BA629DC8-64EE-4B7D-90B0-C0B554E1FD54}" dt="2020-11-26T09:47:09.006" v="207" actId="1076"/>
          <ac:picMkLst>
            <pc:docMk/>
            <pc:sldMk cId="384623300" sldId="262"/>
            <ac:picMk id="19" creationId="{53A0916B-EE1E-4C7D-B401-9A50B95AACEA}"/>
          </ac:picMkLst>
        </pc:picChg>
        <pc:picChg chg="mod topLvl">
          <ac:chgData name="William Cathery" userId="abd8c3f5-ff38-4d7d-ae66-861c24974fed" providerId="ADAL" clId="{BA629DC8-64EE-4B7D-90B0-C0B554E1FD54}" dt="2020-11-26T09:47:10.924" v="208" actId="1076"/>
          <ac:picMkLst>
            <pc:docMk/>
            <pc:sldMk cId="384623300" sldId="262"/>
            <ac:picMk id="20" creationId="{C1D08C19-B38D-42CE-AB67-1EEA9522DC55}"/>
          </ac:picMkLst>
        </pc:picChg>
        <pc:picChg chg="mod topLvl">
          <ac:chgData name="William Cathery" userId="abd8c3f5-ff38-4d7d-ae66-861c24974fed" providerId="ADAL" clId="{BA629DC8-64EE-4B7D-90B0-C0B554E1FD54}" dt="2020-11-26T09:47:06.926" v="206" actId="1076"/>
          <ac:picMkLst>
            <pc:docMk/>
            <pc:sldMk cId="384623300" sldId="262"/>
            <ac:picMk id="21" creationId="{CA5FC46D-7F0B-4133-BC8C-33343A23C08B}"/>
          </ac:picMkLst>
        </pc:picChg>
      </pc:sldChg>
      <pc:sldChg chg="addSp delSp modSp add mod">
        <pc:chgData name="William Cathery" userId="abd8c3f5-ff38-4d7d-ae66-861c24974fed" providerId="ADAL" clId="{BA629DC8-64EE-4B7D-90B0-C0B554E1FD54}" dt="2020-11-26T11:23:16.848" v="634" actId="20577"/>
        <pc:sldMkLst>
          <pc:docMk/>
          <pc:sldMk cId="1333389096" sldId="263"/>
        </pc:sldMkLst>
        <pc:spChg chg="mod">
          <ac:chgData name="William Cathery" userId="abd8c3f5-ff38-4d7d-ae66-861c24974fed" providerId="ADAL" clId="{BA629DC8-64EE-4B7D-90B0-C0B554E1FD54}" dt="2020-11-26T11:23:16.848" v="634" actId="20577"/>
          <ac:spMkLst>
            <pc:docMk/>
            <pc:sldMk cId="1333389096" sldId="263"/>
            <ac:spMk id="13" creationId="{2E47872E-59B4-41AA-B723-06747DABEF79}"/>
          </ac:spMkLst>
        </pc:spChg>
        <pc:graphicFrameChg chg="add del mod">
          <ac:chgData name="William Cathery" userId="abd8c3f5-ff38-4d7d-ae66-861c24974fed" providerId="ADAL" clId="{BA629DC8-64EE-4B7D-90B0-C0B554E1FD54}" dt="2020-11-26T11:21:03.622" v="506" actId="478"/>
          <ac:graphicFrameMkLst>
            <pc:docMk/>
            <pc:sldMk cId="1333389096" sldId="263"/>
            <ac:graphicFrameMk id="2" creationId="{701A5512-C1A2-4A5C-9486-841B9CD2D8E3}"/>
          </ac:graphicFrameMkLst>
        </pc:graphicFrameChg>
        <pc:picChg chg="del">
          <ac:chgData name="William Cathery" userId="abd8c3f5-ff38-4d7d-ae66-861c24974fed" providerId="ADAL" clId="{BA629DC8-64EE-4B7D-90B0-C0B554E1FD54}" dt="2020-11-26T11:17:16.078" v="235" actId="478"/>
          <ac:picMkLst>
            <pc:docMk/>
            <pc:sldMk cId="1333389096" sldId="263"/>
            <ac:picMk id="3" creationId="{576278B3-9697-4846-8E71-B78EEF4F1252}"/>
          </ac:picMkLst>
        </pc:picChg>
        <pc:picChg chg="del">
          <ac:chgData name="William Cathery" userId="abd8c3f5-ff38-4d7d-ae66-861c24974fed" providerId="ADAL" clId="{BA629DC8-64EE-4B7D-90B0-C0B554E1FD54}" dt="2020-11-26T11:17:16.078" v="235" actId="478"/>
          <ac:picMkLst>
            <pc:docMk/>
            <pc:sldMk cId="1333389096" sldId="263"/>
            <ac:picMk id="4" creationId="{9F2C756A-DEA9-41F2-8DDF-9296E4C03F57}"/>
          </ac:picMkLst>
        </pc:picChg>
        <pc:picChg chg="del">
          <ac:chgData name="William Cathery" userId="abd8c3f5-ff38-4d7d-ae66-861c24974fed" providerId="ADAL" clId="{BA629DC8-64EE-4B7D-90B0-C0B554E1FD54}" dt="2020-11-26T11:17:16.078" v="235" actId="478"/>
          <ac:picMkLst>
            <pc:docMk/>
            <pc:sldMk cId="1333389096" sldId="263"/>
            <ac:picMk id="5" creationId="{AB21A5C9-76BA-4184-BB2C-FD572C6FD57F}"/>
          </ac:picMkLst>
        </pc:picChg>
        <pc:picChg chg="del">
          <ac:chgData name="William Cathery" userId="abd8c3f5-ff38-4d7d-ae66-861c24974fed" providerId="ADAL" clId="{BA629DC8-64EE-4B7D-90B0-C0B554E1FD54}" dt="2020-11-26T11:17:16.078" v="235" actId="478"/>
          <ac:picMkLst>
            <pc:docMk/>
            <pc:sldMk cId="1333389096" sldId="263"/>
            <ac:picMk id="6" creationId="{A7CE5908-7434-4F88-9D9F-2717D94473BD}"/>
          </ac:picMkLst>
        </pc:picChg>
        <pc:picChg chg="del">
          <ac:chgData name="William Cathery" userId="abd8c3f5-ff38-4d7d-ae66-861c24974fed" providerId="ADAL" clId="{BA629DC8-64EE-4B7D-90B0-C0B554E1FD54}" dt="2020-11-26T11:17:16.078" v="235" actId="478"/>
          <ac:picMkLst>
            <pc:docMk/>
            <pc:sldMk cId="1333389096" sldId="263"/>
            <ac:picMk id="7" creationId="{4C77A1F8-CA46-46A6-B47B-3ED9591FFC34}"/>
          </ac:picMkLst>
        </pc:picChg>
        <pc:picChg chg="del">
          <ac:chgData name="William Cathery" userId="abd8c3f5-ff38-4d7d-ae66-861c24974fed" providerId="ADAL" clId="{BA629DC8-64EE-4B7D-90B0-C0B554E1FD54}" dt="2020-11-26T11:17:16.078" v="235" actId="478"/>
          <ac:picMkLst>
            <pc:docMk/>
            <pc:sldMk cId="1333389096" sldId="263"/>
            <ac:picMk id="8" creationId="{70DC06D7-1203-4642-BA9F-52A93E36FA20}"/>
          </ac:picMkLst>
        </pc:picChg>
        <pc:picChg chg="del">
          <ac:chgData name="William Cathery" userId="abd8c3f5-ff38-4d7d-ae66-861c24974fed" providerId="ADAL" clId="{BA629DC8-64EE-4B7D-90B0-C0B554E1FD54}" dt="2020-11-26T11:17:16.078" v="235" actId="478"/>
          <ac:picMkLst>
            <pc:docMk/>
            <pc:sldMk cId="1333389096" sldId="263"/>
            <ac:picMk id="9" creationId="{3CD4929C-E5D1-4ABA-96A9-EBE6CC2E4B62}"/>
          </ac:picMkLst>
        </pc:picChg>
        <pc:picChg chg="del">
          <ac:chgData name="William Cathery" userId="abd8c3f5-ff38-4d7d-ae66-861c24974fed" providerId="ADAL" clId="{BA629DC8-64EE-4B7D-90B0-C0B554E1FD54}" dt="2020-11-26T11:17:16.078" v="235" actId="478"/>
          <ac:picMkLst>
            <pc:docMk/>
            <pc:sldMk cId="1333389096" sldId="263"/>
            <ac:picMk id="10" creationId="{BF51EF53-9F2B-429B-A656-17E2CDE05A35}"/>
          </ac:picMkLst>
        </pc:picChg>
        <pc:picChg chg="del">
          <ac:chgData name="William Cathery" userId="abd8c3f5-ff38-4d7d-ae66-861c24974fed" providerId="ADAL" clId="{BA629DC8-64EE-4B7D-90B0-C0B554E1FD54}" dt="2020-11-26T11:17:16.078" v="235" actId="478"/>
          <ac:picMkLst>
            <pc:docMk/>
            <pc:sldMk cId="1333389096" sldId="263"/>
            <ac:picMk id="11" creationId="{1ECC7DBF-D8D4-4947-98A7-E9DA1BB4BAD3}"/>
          </ac:picMkLst>
        </pc:picChg>
        <pc:picChg chg="add mod">
          <ac:chgData name="William Cathery" userId="abd8c3f5-ff38-4d7d-ae66-861c24974fed" providerId="ADAL" clId="{BA629DC8-64EE-4B7D-90B0-C0B554E1FD54}" dt="2020-11-26T11:21:07.823" v="508" actId="1076"/>
          <ac:picMkLst>
            <pc:docMk/>
            <pc:sldMk cId="1333389096" sldId="263"/>
            <ac:picMk id="12" creationId="{6148E9B1-0163-49DC-971A-23E2358A661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443483"/>
            <a:ext cx="5508149" cy="3070719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4632621"/>
            <a:ext cx="4860131" cy="2129494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93463-175D-4DCE-B546-A72A288BA38C}" type="datetimeFigureOut">
              <a:rPr lang="en-GB" smtClean="0"/>
              <a:t>27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4345D-28C3-4968-AF28-A83DC4CE2C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76582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93463-175D-4DCE-B546-A72A288BA38C}" type="datetimeFigureOut">
              <a:rPr lang="en-GB" smtClean="0"/>
              <a:t>27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4345D-28C3-4968-AF28-A83DC4CE2C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15791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469592"/>
            <a:ext cx="1397288" cy="74746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469592"/>
            <a:ext cx="4110861" cy="747466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93463-175D-4DCE-B546-A72A288BA38C}" type="datetimeFigureOut">
              <a:rPr lang="en-GB" smtClean="0"/>
              <a:t>27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4345D-28C3-4968-AF28-A83DC4CE2C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28459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93463-175D-4DCE-B546-A72A288BA38C}" type="datetimeFigureOut">
              <a:rPr lang="en-GB" smtClean="0"/>
              <a:t>27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4345D-28C3-4968-AF28-A83DC4CE2C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31106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2198915"/>
            <a:ext cx="5589151" cy="3668937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5902561"/>
            <a:ext cx="5589151" cy="1929407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93463-175D-4DCE-B546-A72A288BA38C}" type="datetimeFigureOut">
              <a:rPr lang="en-GB" smtClean="0"/>
              <a:t>27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4345D-28C3-4968-AF28-A83DC4CE2C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67649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347957"/>
            <a:ext cx="2754074" cy="55963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347957"/>
            <a:ext cx="2754074" cy="55963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93463-175D-4DCE-B546-A72A288BA38C}" type="datetimeFigureOut">
              <a:rPr lang="en-GB" smtClean="0"/>
              <a:t>27/1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4345D-28C3-4968-AF28-A83DC4CE2C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21237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69593"/>
            <a:ext cx="5589151" cy="170482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2162163"/>
            <a:ext cx="2741417" cy="1059642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3221805"/>
            <a:ext cx="2741417" cy="47387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2162163"/>
            <a:ext cx="2754918" cy="1059642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3221805"/>
            <a:ext cx="2754918" cy="47387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93463-175D-4DCE-B546-A72A288BA38C}" type="datetimeFigureOut">
              <a:rPr lang="en-GB" smtClean="0"/>
              <a:t>27/11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4345D-28C3-4968-AF28-A83DC4CE2C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80543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93463-175D-4DCE-B546-A72A288BA38C}" type="datetimeFigureOut">
              <a:rPr lang="en-GB" smtClean="0"/>
              <a:t>27/11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4345D-28C3-4968-AF28-A83DC4CE2C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705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93463-175D-4DCE-B546-A72A288BA38C}" type="datetimeFigureOut">
              <a:rPr lang="en-GB" smtClean="0"/>
              <a:t>27/11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4345D-28C3-4968-AF28-A83DC4CE2C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3172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88010"/>
            <a:ext cx="2090025" cy="2058035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269940"/>
            <a:ext cx="3280589" cy="6268023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646045"/>
            <a:ext cx="2090025" cy="4902126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93463-175D-4DCE-B546-A72A288BA38C}" type="datetimeFigureOut">
              <a:rPr lang="en-GB" smtClean="0"/>
              <a:t>27/1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4345D-28C3-4968-AF28-A83DC4CE2C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83883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88010"/>
            <a:ext cx="2090025" cy="2058035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269940"/>
            <a:ext cx="3280589" cy="6268023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646045"/>
            <a:ext cx="2090025" cy="4902126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93463-175D-4DCE-B546-A72A288BA38C}" type="datetimeFigureOut">
              <a:rPr lang="en-GB" smtClean="0"/>
              <a:t>27/1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4345D-28C3-4968-AF28-A83DC4CE2C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49006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469593"/>
            <a:ext cx="5589151" cy="17048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347957"/>
            <a:ext cx="5589151" cy="55963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8174974"/>
            <a:ext cx="1458039" cy="4695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893463-175D-4DCE-B546-A72A288BA38C}" type="datetimeFigureOut">
              <a:rPr lang="en-GB" smtClean="0"/>
              <a:t>27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8174974"/>
            <a:ext cx="2187059" cy="4695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8174974"/>
            <a:ext cx="1458039" cy="4695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74345D-28C3-4968-AF28-A83DC4CE2C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65406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4.jpeg"/><Relationship Id="rId4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eg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76278B3-9697-4846-8E71-B78EEF4F125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7264" y="1834539"/>
            <a:ext cx="1780181" cy="175345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F2C756A-DEA9-41F2-8DDF-9296E4C03F5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7265" y="81773"/>
            <a:ext cx="1780181" cy="175345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B21A5C9-76BA-4184-BB2C-FD572C6FD57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77359" y="81773"/>
            <a:ext cx="1780181" cy="175345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7CE5908-7434-4F88-9D9F-2717D94473B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62311" y="1832857"/>
            <a:ext cx="1780181" cy="175345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C77A1F8-CA46-46A6-B47B-3ED9591FFC3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88676" y="1832857"/>
            <a:ext cx="1780181" cy="175345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0DC06D7-1203-4642-BA9F-52A93E36FA2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7264" y="3693012"/>
            <a:ext cx="1780164" cy="175343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CD4929C-E5D1-4ABA-96A9-EBE6CC2E4B6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153937" y="3693012"/>
            <a:ext cx="1780164" cy="1753435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BF51EF53-9F2B-429B-A656-17E2CDE05A3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088676" y="3693012"/>
            <a:ext cx="1780181" cy="175345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1ECC7DBF-D8D4-4947-98A7-E9DA1BB4BAD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164318" y="81773"/>
            <a:ext cx="1780181" cy="1753452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2E47872E-59B4-41AA-B723-06747DABEF79}"/>
              </a:ext>
            </a:extLst>
          </p:cNvPr>
          <p:cNvSpPr txBox="1"/>
          <p:nvPr/>
        </p:nvSpPr>
        <p:spPr>
          <a:xfrm>
            <a:off x="383773" y="5678607"/>
            <a:ext cx="564050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Representative histogram for each surface marker analyzed by flow cytometry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ative control staining profiles are demonstrated by the red histograms and specific antibody staining profiles are demonstrated by the blue histograms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199282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2E47872E-59B4-41AA-B723-06747DABEF79}"/>
              </a:ext>
            </a:extLst>
          </p:cNvPr>
          <p:cNvSpPr txBox="1"/>
          <p:nvPr/>
        </p:nvSpPr>
        <p:spPr>
          <a:xfrm>
            <a:off x="383771" y="2093913"/>
            <a:ext cx="564050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: Expression profile of MSCs cultured in either MSC medium or EGM-2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 cytometry data for MSC expression profile after culturing for 7 days in either MSC medium or endothelial growth medium-2 (EGM). Data represent means (± S.E.M). N = 2 biological replicates.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6148E9B1-0163-49DC-971A-23E2358A66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0912" y="141288"/>
            <a:ext cx="4086225" cy="19526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33890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4D902354-ADF0-48FD-ABA4-98ECB65F7DE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17982" y="378586"/>
            <a:ext cx="835819" cy="113495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AD3DFE9-A2BF-49D7-AEEE-32F3C2D2902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69097" y="265468"/>
            <a:ext cx="730250" cy="123825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E9BE345-ADB8-4612-9863-37F18C1603BD}"/>
              </a:ext>
            </a:extLst>
          </p:cNvPr>
          <p:cNvSpPr txBox="1"/>
          <p:nvPr/>
        </p:nvSpPr>
        <p:spPr>
          <a:xfrm>
            <a:off x="1147509" y="701421"/>
            <a:ext cx="9332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dirty="0"/>
              <a:t>α</a:t>
            </a:r>
            <a:r>
              <a:rPr lang="en-GB" sz="1000" dirty="0"/>
              <a:t>SMA (42kDa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BEE1EB1-220B-4272-A1E0-7A6F37B48211}"/>
              </a:ext>
            </a:extLst>
          </p:cNvPr>
          <p:cNvSpPr txBox="1"/>
          <p:nvPr/>
        </p:nvSpPr>
        <p:spPr>
          <a:xfrm>
            <a:off x="1136659" y="874971"/>
            <a:ext cx="10759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Calponin (34kDa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253699A-5B64-4E50-B2EE-D308308E377D}"/>
              </a:ext>
            </a:extLst>
          </p:cNvPr>
          <p:cNvSpPr txBox="1"/>
          <p:nvPr/>
        </p:nvSpPr>
        <p:spPr>
          <a:xfrm>
            <a:off x="1147509" y="1181074"/>
            <a:ext cx="11544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err="1"/>
              <a:t>Transgelin</a:t>
            </a:r>
            <a:r>
              <a:rPr lang="en-GB" sz="1000" dirty="0"/>
              <a:t> (22kDa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7F22A0B-4237-4BA9-B487-C552C7CD4ADF}"/>
              </a:ext>
            </a:extLst>
          </p:cNvPr>
          <p:cNvSpPr txBox="1"/>
          <p:nvPr/>
        </p:nvSpPr>
        <p:spPr>
          <a:xfrm>
            <a:off x="1136659" y="568869"/>
            <a:ext cx="1117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dirty="0"/>
              <a:t>Β</a:t>
            </a:r>
            <a:r>
              <a:rPr lang="en-GB" sz="1000" dirty="0"/>
              <a:t>-Tubulin (55kDa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7E9E167-5D10-429D-9FA3-A01A6F085679}"/>
              </a:ext>
            </a:extLst>
          </p:cNvPr>
          <p:cNvSpPr txBox="1"/>
          <p:nvPr/>
        </p:nvSpPr>
        <p:spPr>
          <a:xfrm>
            <a:off x="3101192" y="446058"/>
            <a:ext cx="11496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SM-MHC (227kDa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B12FBBE-86EE-4707-BC36-FEC7EB14E4CA}"/>
              </a:ext>
            </a:extLst>
          </p:cNvPr>
          <p:cNvSpPr txBox="1"/>
          <p:nvPr/>
        </p:nvSpPr>
        <p:spPr>
          <a:xfrm>
            <a:off x="563710" y="401035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F5F02C7-19A0-4437-80B2-4486E3FB01E4}"/>
              </a:ext>
            </a:extLst>
          </p:cNvPr>
          <p:cNvSpPr txBox="1"/>
          <p:nvPr/>
        </p:nvSpPr>
        <p:spPr>
          <a:xfrm>
            <a:off x="858604" y="401035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7AC43AF-40DC-4BBF-8797-8BA0C4D0AA8E}"/>
              </a:ext>
            </a:extLst>
          </p:cNvPr>
          <p:cNvSpPr txBox="1"/>
          <p:nvPr/>
        </p:nvSpPr>
        <p:spPr>
          <a:xfrm>
            <a:off x="2496722" y="315784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E9EA2FD-A561-4018-8EC4-2E79B6D7CB84}"/>
              </a:ext>
            </a:extLst>
          </p:cNvPr>
          <p:cNvSpPr txBox="1"/>
          <p:nvPr/>
        </p:nvSpPr>
        <p:spPr>
          <a:xfrm>
            <a:off x="2792937" y="33097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C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154B5F7-AC31-443F-B252-61ADA284D504}"/>
              </a:ext>
            </a:extLst>
          </p:cNvPr>
          <p:cNvSpPr txBox="1"/>
          <p:nvPr/>
        </p:nvSpPr>
        <p:spPr>
          <a:xfrm>
            <a:off x="722154" y="401035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C2CFE72-BA30-4843-8AF6-011ABCCD09C0}"/>
              </a:ext>
            </a:extLst>
          </p:cNvPr>
          <p:cNvSpPr txBox="1"/>
          <p:nvPr/>
        </p:nvSpPr>
        <p:spPr>
          <a:xfrm>
            <a:off x="989008" y="401035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EAFABA3-63D9-405A-99D3-E33C9DC157AC}"/>
              </a:ext>
            </a:extLst>
          </p:cNvPr>
          <p:cNvSpPr txBox="1"/>
          <p:nvPr/>
        </p:nvSpPr>
        <p:spPr>
          <a:xfrm>
            <a:off x="2643901" y="315784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D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521B8D7-D7E0-4A82-9D21-8E30B9934828}"/>
              </a:ext>
            </a:extLst>
          </p:cNvPr>
          <p:cNvSpPr txBox="1"/>
          <p:nvPr/>
        </p:nvSpPr>
        <p:spPr>
          <a:xfrm>
            <a:off x="2943056" y="323777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D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916290D-7D32-4375-89CD-D19CD7F26BCD}"/>
              </a:ext>
            </a:extLst>
          </p:cNvPr>
          <p:cNvSpPr txBox="1"/>
          <p:nvPr/>
        </p:nvSpPr>
        <p:spPr>
          <a:xfrm>
            <a:off x="95277" y="3186985"/>
            <a:ext cx="426157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Supplementary Figure 3: Representative western blots used for determination of protein changes in Figure 4E - F. </a:t>
            </a:r>
            <a:r>
              <a:rPr lang="en-US" sz="1200" dirty="0"/>
              <a:t>(</a:t>
            </a:r>
            <a:r>
              <a:rPr lang="en-US" sz="1200" b="1" dirty="0"/>
              <a:t>A – B</a:t>
            </a:r>
            <a:r>
              <a:rPr lang="en-US" sz="1200" dirty="0"/>
              <a:t>) NG2 UCPs. (</a:t>
            </a:r>
            <a:r>
              <a:rPr lang="en-US" sz="1200" b="1" dirty="0"/>
              <a:t>C – D</a:t>
            </a:r>
            <a:r>
              <a:rPr lang="en-US" sz="1200" dirty="0"/>
              <a:t>) MSCs. C represents control non-differentiated and D represents differentiated cells.</a:t>
            </a:r>
            <a:endParaRPr lang="en-GB" sz="1200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D8F8B6C3-71D5-43A0-BBBF-82E01CD18F2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80279" y="1743463"/>
            <a:ext cx="1175065" cy="1323191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EABBFDB2-851F-4AE1-887B-20D03D1E6368}"/>
              </a:ext>
            </a:extLst>
          </p:cNvPr>
          <p:cNvSpPr txBox="1"/>
          <p:nvPr/>
        </p:nvSpPr>
        <p:spPr>
          <a:xfrm>
            <a:off x="95277" y="18239"/>
            <a:ext cx="373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(A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E98B1D7-3AEC-4E04-AA23-DCD62309AF64}"/>
              </a:ext>
            </a:extLst>
          </p:cNvPr>
          <p:cNvSpPr txBox="1"/>
          <p:nvPr/>
        </p:nvSpPr>
        <p:spPr>
          <a:xfrm>
            <a:off x="2025684" y="5328"/>
            <a:ext cx="3674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(B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FD2AA83-6184-43F4-B595-23B7377D14F2}"/>
              </a:ext>
            </a:extLst>
          </p:cNvPr>
          <p:cNvSpPr txBox="1"/>
          <p:nvPr/>
        </p:nvSpPr>
        <p:spPr>
          <a:xfrm>
            <a:off x="95277" y="1535992"/>
            <a:ext cx="3626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(C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B353315-0CB7-4F94-8EEA-D4A8C61F6C62}"/>
              </a:ext>
            </a:extLst>
          </p:cNvPr>
          <p:cNvSpPr txBox="1"/>
          <p:nvPr/>
        </p:nvSpPr>
        <p:spPr>
          <a:xfrm>
            <a:off x="2018907" y="1535991"/>
            <a:ext cx="3786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(D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AEC2F13-3AD3-44A9-86CE-0B490A6D310F}"/>
              </a:ext>
            </a:extLst>
          </p:cNvPr>
          <p:cNvSpPr txBox="1"/>
          <p:nvPr/>
        </p:nvSpPr>
        <p:spPr>
          <a:xfrm>
            <a:off x="3555056" y="1822984"/>
            <a:ext cx="11496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SM-MHC (227kDa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5944004-9D64-4517-8C40-C86F06DCECE2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06779" y="1822534"/>
            <a:ext cx="900003" cy="1154595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77919009-C757-4F5A-806C-57688D6E3BAB}"/>
              </a:ext>
            </a:extLst>
          </p:cNvPr>
          <p:cNvSpPr txBox="1"/>
          <p:nvPr/>
        </p:nvSpPr>
        <p:spPr>
          <a:xfrm>
            <a:off x="690508" y="1824140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C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5DDA704-6BBA-44EE-A9F5-7B9C042FD257}"/>
              </a:ext>
            </a:extLst>
          </p:cNvPr>
          <p:cNvSpPr txBox="1"/>
          <p:nvPr/>
        </p:nvSpPr>
        <p:spPr>
          <a:xfrm>
            <a:off x="847774" y="1824140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C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307A838-E644-4A96-8437-41258DEB0F15}"/>
              </a:ext>
            </a:extLst>
          </p:cNvPr>
          <p:cNvSpPr txBox="1"/>
          <p:nvPr/>
        </p:nvSpPr>
        <p:spPr>
          <a:xfrm>
            <a:off x="1005040" y="1824140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D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522DD78-01FD-47D6-ADE4-0C400D1A08B4}"/>
              </a:ext>
            </a:extLst>
          </p:cNvPr>
          <p:cNvSpPr txBox="1"/>
          <p:nvPr/>
        </p:nvSpPr>
        <p:spPr>
          <a:xfrm>
            <a:off x="1171924" y="1824140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D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80A53CC-7FC9-4B61-B13E-5B5CBFEDCE69}"/>
              </a:ext>
            </a:extLst>
          </p:cNvPr>
          <p:cNvSpPr txBox="1"/>
          <p:nvPr/>
        </p:nvSpPr>
        <p:spPr>
          <a:xfrm>
            <a:off x="2858007" y="1708053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C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3781F34-B763-420F-8FFF-25470522A2BD}"/>
              </a:ext>
            </a:extLst>
          </p:cNvPr>
          <p:cNvSpPr txBox="1"/>
          <p:nvPr/>
        </p:nvSpPr>
        <p:spPr>
          <a:xfrm>
            <a:off x="3015273" y="1708053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C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6AB5B3C-0F88-4938-A871-F543CE56F266}"/>
              </a:ext>
            </a:extLst>
          </p:cNvPr>
          <p:cNvSpPr txBox="1"/>
          <p:nvPr/>
        </p:nvSpPr>
        <p:spPr>
          <a:xfrm>
            <a:off x="3172539" y="1708053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D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2E30252-EFB7-4EE7-B07A-8BDB9ADAB21B}"/>
              </a:ext>
            </a:extLst>
          </p:cNvPr>
          <p:cNvSpPr txBox="1"/>
          <p:nvPr/>
        </p:nvSpPr>
        <p:spPr>
          <a:xfrm>
            <a:off x="3339423" y="1708053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D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0F1F48A-C49F-47B5-A937-C274A4ECF646}"/>
              </a:ext>
            </a:extLst>
          </p:cNvPr>
          <p:cNvSpPr txBox="1"/>
          <p:nvPr/>
        </p:nvSpPr>
        <p:spPr>
          <a:xfrm>
            <a:off x="1352881" y="2125804"/>
            <a:ext cx="9332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dirty="0"/>
              <a:t>α</a:t>
            </a:r>
            <a:r>
              <a:rPr lang="en-GB" sz="1000" dirty="0"/>
              <a:t>SMA (42kDa)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8B9E40D-0BDE-4720-BBCB-792B6AF6EA2C}"/>
              </a:ext>
            </a:extLst>
          </p:cNvPr>
          <p:cNvSpPr txBox="1"/>
          <p:nvPr/>
        </p:nvSpPr>
        <p:spPr>
          <a:xfrm>
            <a:off x="1342031" y="2299354"/>
            <a:ext cx="10759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Calponin (34kDa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F00EB86-23C0-4929-BDBF-77BBC97EB24A}"/>
              </a:ext>
            </a:extLst>
          </p:cNvPr>
          <p:cNvSpPr txBox="1"/>
          <p:nvPr/>
        </p:nvSpPr>
        <p:spPr>
          <a:xfrm>
            <a:off x="1352881" y="2605457"/>
            <a:ext cx="11544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err="1"/>
              <a:t>Transgelin</a:t>
            </a:r>
            <a:r>
              <a:rPr lang="en-GB" sz="1000" dirty="0"/>
              <a:t> (22kDa)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E840F3A-91E6-4F2A-9C2C-F08237EF8553}"/>
              </a:ext>
            </a:extLst>
          </p:cNvPr>
          <p:cNvSpPr txBox="1"/>
          <p:nvPr/>
        </p:nvSpPr>
        <p:spPr>
          <a:xfrm>
            <a:off x="1342031" y="1993252"/>
            <a:ext cx="1117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dirty="0"/>
              <a:t>Β</a:t>
            </a:r>
            <a:r>
              <a:rPr lang="en-GB" sz="1000" dirty="0"/>
              <a:t>-Tubulin (55kDa)</a:t>
            </a:r>
          </a:p>
        </p:txBody>
      </p:sp>
    </p:spTree>
    <p:extLst>
      <p:ext uri="{BB962C8B-B14F-4D97-AF65-F5344CB8AC3E}">
        <p14:creationId xmlns:p14="http://schemas.microsoft.com/office/powerpoint/2010/main" val="18530636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AA3B2781-694B-4691-BFE2-02608299C74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8627" t="35397" r="58685" b="56731"/>
          <a:stretch/>
        </p:blipFill>
        <p:spPr>
          <a:xfrm>
            <a:off x="1951037" y="449731"/>
            <a:ext cx="794753" cy="3683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80B9F5C-1D3B-4FB3-842A-9C595EE170B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1625" t="26490" r="45222" b="63153"/>
          <a:stretch/>
        </p:blipFill>
        <p:spPr>
          <a:xfrm>
            <a:off x="3487737" y="383485"/>
            <a:ext cx="794752" cy="467503"/>
          </a:xfrm>
          <a:prstGeom prst="rect">
            <a:avLst/>
          </a:prstGeom>
        </p:spPr>
      </p:pic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0638A2FF-F767-4BAC-861A-6A520DE6384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3304403"/>
              </p:ext>
            </p:extLst>
          </p:nvPr>
        </p:nvGraphicFramePr>
        <p:xfrm>
          <a:off x="991784" y="1104472"/>
          <a:ext cx="4433920" cy="15849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4240">
                  <a:extLst>
                    <a:ext uri="{9D8B030D-6E8A-4147-A177-3AD203B41FA5}">
                      <a16:colId xmlns:a16="http://schemas.microsoft.com/office/drawing/2014/main" val="641800780"/>
                    </a:ext>
                  </a:extLst>
                </a:gridCol>
                <a:gridCol w="554240">
                  <a:extLst>
                    <a:ext uri="{9D8B030D-6E8A-4147-A177-3AD203B41FA5}">
                      <a16:colId xmlns:a16="http://schemas.microsoft.com/office/drawing/2014/main" val="717030187"/>
                    </a:ext>
                  </a:extLst>
                </a:gridCol>
                <a:gridCol w="554240">
                  <a:extLst>
                    <a:ext uri="{9D8B030D-6E8A-4147-A177-3AD203B41FA5}">
                      <a16:colId xmlns:a16="http://schemas.microsoft.com/office/drawing/2014/main" val="1666286948"/>
                    </a:ext>
                  </a:extLst>
                </a:gridCol>
                <a:gridCol w="554240">
                  <a:extLst>
                    <a:ext uri="{9D8B030D-6E8A-4147-A177-3AD203B41FA5}">
                      <a16:colId xmlns:a16="http://schemas.microsoft.com/office/drawing/2014/main" val="1341176786"/>
                    </a:ext>
                  </a:extLst>
                </a:gridCol>
                <a:gridCol w="554240">
                  <a:extLst>
                    <a:ext uri="{9D8B030D-6E8A-4147-A177-3AD203B41FA5}">
                      <a16:colId xmlns:a16="http://schemas.microsoft.com/office/drawing/2014/main" val="2540913078"/>
                    </a:ext>
                  </a:extLst>
                </a:gridCol>
                <a:gridCol w="554240">
                  <a:extLst>
                    <a:ext uri="{9D8B030D-6E8A-4147-A177-3AD203B41FA5}">
                      <a16:colId xmlns:a16="http://schemas.microsoft.com/office/drawing/2014/main" val="1681791084"/>
                    </a:ext>
                  </a:extLst>
                </a:gridCol>
                <a:gridCol w="554240">
                  <a:extLst>
                    <a:ext uri="{9D8B030D-6E8A-4147-A177-3AD203B41FA5}">
                      <a16:colId xmlns:a16="http://schemas.microsoft.com/office/drawing/2014/main" val="1203214427"/>
                    </a:ext>
                  </a:extLst>
                </a:gridCol>
                <a:gridCol w="554240">
                  <a:extLst>
                    <a:ext uri="{9D8B030D-6E8A-4147-A177-3AD203B41FA5}">
                      <a16:colId xmlns:a16="http://schemas.microsoft.com/office/drawing/2014/main" val="3006981323"/>
                    </a:ext>
                  </a:extLst>
                </a:gridCol>
              </a:tblGrid>
              <a:tr h="227983">
                <a:tc>
                  <a:txBody>
                    <a:bodyPr/>
                    <a:lstStyle/>
                    <a:p>
                      <a:r>
                        <a:rPr lang="en-GB" sz="1000" dirty="0" err="1"/>
                        <a:t>Pos</a:t>
                      </a:r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 err="1"/>
                        <a:t>Pos</a:t>
                      </a:r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/>
                        <a:t>Ne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/>
                        <a:t>Ne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/>
                        <a:t>MMP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/>
                        <a:t>MMP-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/>
                        <a:t>MMP-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/>
                        <a:t>MMP-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22651956"/>
                  </a:ext>
                </a:extLst>
              </a:tr>
              <a:tr h="227983">
                <a:tc>
                  <a:txBody>
                    <a:bodyPr/>
                    <a:lstStyle/>
                    <a:p>
                      <a:r>
                        <a:rPr lang="en-GB" sz="1000" dirty="0" err="1"/>
                        <a:t>Pos</a:t>
                      </a:r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 err="1"/>
                        <a:t>Pos</a:t>
                      </a:r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/>
                        <a:t>Ne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/>
                        <a:t>Ne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/>
                        <a:t>MMP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/>
                        <a:t>MMP-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/>
                        <a:t>MMP-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/>
                        <a:t>MMP-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74653560"/>
                  </a:ext>
                </a:extLst>
              </a:tr>
              <a:tr h="227983">
                <a:tc>
                  <a:txBody>
                    <a:bodyPr/>
                    <a:lstStyle/>
                    <a:p>
                      <a:r>
                        <a:rPr lang="en-GB" sz="1000" dirty="0"/>
                        <a:t>MMP-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/>
                        <a:t>MMP-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/>
                        <a:t>MMP-1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/>
                        <a:t>TIMP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/>
                        <a:t>TIMP-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/>
                        <a:t>TIMP-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/>
                        <a:t>Ne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 err="1"/>
                        <a:t>Pos</a:t>
                      </a:r>
                      <a:endParaRPr lang="en-GB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7151246"/>
                  </a:ext>
                </a:extLst>
              </a:tr>
              <a:tr h="227983">
                <a:tc>
                  <a:txBody>
                    <a:bodyPr/>
                    <a:lstStyle/>
                    <a:p>
                      <a:r>
                        <a:rPr lang="en-GB" sz="1000" dirty="0"/>
                        <a:t>MMP-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/>
                        <a:t>MMP-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/>
                        <a:t>MMP-1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/>
                        <a:t>TIMP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/>
                        <a:t>TIMP-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/>
                        <a:t>TIMP-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/>
                        <a:t>Ne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dirty="0" err="1"/>
                        <a:t>Pos</a:t>
                      </a:r>
                      <a:endParaRPr lang="en-GB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77978754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587C8B08-1AE4-4DE0-99AC-917357539E8A}"/>
              </a:ext>
            </a:extLst>
          </p:cNvPr>
          <p:cNvSpPr txBox="1"/>
          <p:nvPr/>
        </p:nvSpPr>
        <p:spPr>
          <a:xfrm>
            <a:off x="1524793" y="252679"/>
            <a:ext cx="373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(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7CC8703-EAFF-4AD1-BA06-E0C5BB689A31}"/>
              </a:ext>
            </a:extLst>
          </p:cNvPr>
          <p:cNvSpPr txBox="1"/>
          <p:nvPr/>
        </p:nvSpPr>
        <p:spPr>
          <a:xfrm>
            <a:off x="3056383" y="252679"/>
            <a:ext cx="3674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(B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E22969A-F3FD-4189-A09E-18E63452E411}"/>
              </a:ext>
            </a:extLst>
          </p:cNvPr>
          <p:cNvSpPr txBox="1"/>
          <p:nvPr/>
        </p:nvSpPr>
        <p:spPr>
          <a:xfrm>
            <a:off x="1316002" y="816119"/>
            <a:ext cx="3626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(C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52F948A-1040-40AF-8667-C72BEA0A1625}"/>
              </a:ext>
            </a:extLst>
          </p:cNvPr>
          <p:cNvSpPr txBox="1"/>
          <p:nvPr/>
        </p:nvSpPr>
        <p:spPr>
          <a:xfrm>
            <a:off x="839423" y="2756394"/>
            <a:ext cx="474323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Supplementary Figure 4: Representative Human MMP Antibody Array-Membranes used for determination of MMP presence in NG2 UCPs</a:t>
            </a:r>
            <a:r>
              <a:rPr lang="en-GB" sz="1200" dirty="0"/>
              <a:t>. (</a:t>
            </a:r>
            <a:r>
              <a:rPr lang="en-GB" sz="1200" b="1" dirty="0"/>
              <a:t>A</a:t>
            </a:r>
            <a:r>
              <a:rPr lang="en-GB" sz="1200" dirty="0"/>
              <a:t>) Representative membrane for MMP presence in cell lysates. (</a:t>
            </a:r>
            <a:r>
              <a:rPr lang="en-GB" sz="1200" b="1" dirty="0"/>
              <a:t>B</a:t>
            </a:r>
            <a:r>
              <a:rPr lang="en-GB" sz="1200" dirty="0"/>
              <a:t>) Representative membrane for MMP presence in CM. (</a:t>
            </a:r>
            <a:r>
              <a:rPr lang="en-GB" sz="1200" b="1" dirty="0"/>
              <a:t>C</a:t>
            </a:r>
            <a:r>
              <a:rPr lang="en-GB" sz="1200" dirty="0"/>
              <a:t>) Human MMP Antibody Array-Membrane map.</a:t>
            </a:r>
          </a:p>
        </p:txBody>
      </p:sp>
    </p:spTree>
    <p:extLst>
      <p:ext uri="{BB962C8B-B14F-4D97-AF65-F5344CB8AC3E}">
        <p14:creationId xmlns:p14="http://schemas.microsoft.com/office/powerpoint/2010/main" val="31083680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2E47872E-59B4-41AA-B723-06747DABEF79}"/>
              </a:ext>
            </a:extLst>
          </p:cNvPr>
          <p:cNvSpPr txBox="1"/>
          <p:nvPr/>
        </p:nvSpPr>
        <p:spPr>
          <a:xfrm>
            <a:off x="260675" y="5100114"/>
            <a:ext cx="564050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: Bioreactor system set up. (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Matrix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aft positioned in crown for static conditioning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lose up of 3DCulture Pro bioreactor chamber housing Pericyte seede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Matrix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duit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Bioreactor system comprising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sterflex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/S digital 07528-20 peristaltic pump, tubing and 3DCulture Pro bioreactor chamber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53A0916B-EE1E-4C7D-B401-9A50B95AACE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45960" y="2492776"/>
            <a:ext cx="2925217" cy="2339493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C1D08C19-B38D-42CE-AB67-1EEA9522DC5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080930" y="544955"/>
            <a:ext cx="1090247" cy="1679976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CA5FC46D-7F0B-4133-BC8C-33343A23C08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45960" y="538867"/>
            <a:ext cx="1602587" cy="1686064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7A6BE58F-8844-4D76-8E71-01788EF1CAE9}"/>
              </a:ext>
            </a:extLst>
          </p:cNvPr>
          <p:cNvSpPr txBox="1"/>
          <p:nvPr/>
        </p:nvSpPr>
        <p:spPr>
          <a:xfrm>
            <a:off x="872140" y="266445"/>
            <a:ext cx="373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(A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880915C-F039-431F-B2D7-0E5982A6B34F}"/>
              </a:ext>
            </a:extLst>
          </p:cNvPr>
          <p:cNvSpPr txBox="1"/>
          <p:nvPr/>
        </p:nvSpPr>
        <p:spPr>
          <a:xfrm>
            <a:off x="2777829" y="271022"/>
            <a:ext cx="3674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(B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593358A-38CC-4F76-B06F-CB27F4B90E71}"/>
              </a:ext>
            </a:extLst>
          </p:cNvPr>
          <p:cNvSpPr txBox="1"/>
          <p:nvPr/>
        </p:nvSpPr>
        <p:spPr>
          <a:xfrm>
            <a:off x="872140" y="2211200"/>
            <a:ext cx="3626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(C)</a:t>
            </a:r>
          </a:p>
        </p:txBody>
      </p:sp>
    </p:spTree>
    <p:extLst>
      <p:ext uri="{BB962C8B-B14F-4D97-AF65-F5344CB8AC3E}">
        <p14:creationId xmlns:p14="http://schemas.microsoft.com/office/powerpoint/2010/main" val="3846233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60CF2F55BD34B408DCC15B6E01C2259" ma:contentTypeVersion="13" ma:contentTypeDescription="Create a new document." ma:contentTypeScope="" ma:versionID="73f2e0e0e0621897bb1b733739d49941">
  <xsd:schema xmlns:xsd="http://www.w3.org/2001/XMLSchema" xmlns:xs="http://www.w3.org/2001/XMLSchema" xmlns:p="http://schemas.microsoft.com/office/2006/metadata/properties" xmlns:ns3="1c763d33-6a12-4838-92c6-dc2a2b40372e" xmlns:ns4="782557ab-0c5b-47ab-a006-2e65f2bad448" targetNamespace="http://schemas.microsoft.com/office/2006/metadata/properties" ma:root="true" ma:fieldsID="41b0ac2a0f1ed2b224af71562ccf1530" ns3:_="" ns4:_="">
    <xsd:import namespace="1c763d33-6a12-4838-92c6-dc2a2b40372e"/>
    <xsd:import namespace="782557ab-0c5b-47ab-a006-2e65f2bad448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Location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c763d33-6a12-4838-92c6-dc2a2b40372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AutoTags" ma:index="11" nillable="true" ma:displayName="MediaServiceAutoTags" ma:description="" ma:internalName="MediaServiceAutoTags" ma:readOnly="true">
      <xsd:simpleType>
        <xsd:restriction base="dms:Text"/>
      </xsd:simpleType>
    </xsd:element>
    <xsd:element name="MediaServiceLocation" ma:index="12" nillable="true" ma:displayName="MediaServiceLocation" ma:description="" ma:internalName="MediaServiceLocation" ma:readOnly="true">
      <xsd:simpleType>
        <xsd:restriction base="dms:Text"/>
      </xsd:simpleType>
    </xsd:element>
    <xsd:element name="MediaServiceOCR" ma:index="13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2557ab-0c5b-47ab-a006-2e65f2bad448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153DAA8F-6020-44C2-81D5-B10CED1E81CB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DC4FA419-D49A-4B75-919A-4F9811550171}">
  <ds:schemaRefs>
    <ds:schemaRef ds:uri="http://purl.org/dc/elements/1.1/"/>
    <ds:schemaRef ds:uri="http://schemas.openxmlformats.org/package/2006/metadata/core-properties"/>
    <ds:schemaRef ds:uri="http://purl.org/dc/dcmitype/"/>
    <ds:schemaRef ds:uri="1c763d33-6a12-4838-92c6-dc2a2b40372e"/>
    <ds:schemaRef ds:uri="782557ab-0c5b-47ab-a006-2e65f2bad448"/>
    <ds:schemaRef ds:uri="http://schemas.microsoft.com/office/2006/metadata/properties"/>
    <ds:schemaRef ds:uri="http://www.w3.org/XML/1998/namespace"/>
    <ds:schemaRef ds:uri="http://schemas.microsoft.com/office/2006/documentManagement/types"/>
    <ds:schemaRef ds:uri="http://schemas.microsoft.com/office/infopath/2007/PartnerControls"/>
    <ds:schemaRef ds:uri="http://purl.org/dc/terms/"/>
  </ds:schemaRefs>
</ds:datastoreItem>
</file>

<file path=customXml/itemProps3.xml><?xml version="1.0" encoding="utf-8"?>
<ds:datastoreItem xmlns:ds="http://schemas.openxmlformats.org/officeDocument/2006/customXml" ds:itemID="{5919AFEA-3E2E-4E95-AF2B-CEDD65E30B6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c763d33-6a12-4838-92c6-dc2a2b40372e"/>
    <ds:schemaRef ds:uri="782557ab-0c5b-47ab-a006-2e65f2bad44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18</TotalTime>
  <Words>369</Words>
  <Application>Microsoft Office PowerPoint</Application>
  <PresentationFormat>Custom</PresentationFormat>
  <Paragraphs>73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ll Cathery</dc:creator>
  <cp:lastModifiedBy>Will Cathery</cp:lastModifiedBy>
  <cp:revision>7</cp:revision>
  <dcterms:created xsi:type="dcterms:W3CDTF">2020-05-27T08:58:56Z</dcterms:created>
  <dcterms:modified xsi:type="dcterms:W3CDTF">2020-11-27T10:01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60CF2F55BD34B408DCC15B6E01C2259</vt:lpwstr>
  </property>
</Properties>
</file>